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7" r:id="rId2"/>
    <p:sldId id="258" r:id="rId3"/>
    <p:sldId id="259" r:id="rId4"/>
    <p:sldId id="264" r:id="rId5"/>
    <p:sldId id="260" r:id="rId6"/>
    <p:sldId id="261" r:id="rId7"/>
    <p:sldId id="267" r:id="rId8"/>
    <p:sldId id="265" r:id="rId9"/>
    <p:sldId id="266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2959" autoAdjust="0"/>
  </p:normalViewPr>
  <p:slideViewPr>
    <p:cSldViewPr>
      <p:cViewPr varScale="1">
        <p:scale>
          <a:sx n="93" d="100"/>
          <a:sy n="93" d="100"/>
        </p:scale>
        <p:origin x="-38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yc\Flow%20Cytometry\Summary%20for%203%20stresses.xls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yc\Flow%20Cytometry\Summary%20for%203%20stresses.xls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yc\Flow%20Cytometry\Summary%20for%203%20stresse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nciis-p001.nci.nih.gov\Home03\apreliko\Olga\JGr\Manuscripts\Myc_JMJ\Summary%20for%206genes_Cytoto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753246753246752"/>
          <c:y val="0.11304347826086956"/>
          <c:w val="0.73701298701298701"/>
          <c:h val="0.695652173913043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Birc&amp;Sumo'!$K$63:$N$63</c:f>
                <c:numCache>
                  <c:formatCode>General</c:formatCode>
                  <c:ptCount val="4"/>
                  <c:pt idx="0">
                    <c:v>5.7115046778150616E-2</c:v>
                  </c:pt>
                  <c:pt idx="1">
                    <c:v>0.12951316413318903</c:v>
                  </c:pt>
                  <c:pt idx="2">
                    <c:v>5.0151867266914736E-2</c:v>
                  </c:pt>
                  <c:pt idx="3">
                    <c:v>0.14171927354168576</c:v>
                  </c:pt>
                </c:numCache>
              </c:numRef>
            </c:plus>
            <c:minus>
              <c:numRef>
                <c:f>'Birc&amp;Sumo'!$K$63:$N$63</c:f>
                <c:numCache>
                  <c:formatCode>General</c:formatCode>
                  <c:ptCount val="4"/>
                  <c:pt idx="0">
                    <c:v>5.7115046778150616E-2</c:v>
                  </c:pt>
                  <c:pt idx="1">
                    <c:v>0.12951316413318903</c:v>
                  </c:pt>
                  <c:pt idx="2">
                    <c:v>5.0151867266914736E-2</c:v>
                  </c:pt>
                  <c:pt idx="3">
                    <c:v>0.14171927354168576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Birc&amp;Sumo'!$K$60:$N$60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'Birc&amp;Sumo'!$K$61:$N$61</c:f>
              <c:numCache>
                <c:formatCode>General</c:formatCode>
                <c:ptCount val="4"/>
                <c:pt idx="0">
                  <c:v>1.0000751171974647</c:v>
                </c:pt>
                <c:pt idx="1">
                  <c:v>2.1348723286944153</c:v>
                </c:pt>
                <c:pt idx="2">
                  <c:v>1.1926999493136565</c:v>
                </c:pt>
                <c:pt idx="3">
                  <c:v>3.64930215339786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197888"/>
        <c:axId val="102203776"/>
      </c:barChart>
      <c:catAx>
        <c:axId val="102197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20377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2203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197888"/>
        <c:crosses val="autoZero"/>
        <c:crossBetween val="between"/>
        <c:majorUnit val="1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925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Ube2O!$A$48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rgbClr val="9999FF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Ube2O!$B$51:$E$51</c:f>
                <c:numCache>
                  <c:formatCode>General</c:formatCode>
                  <c:ptCount val="4"/>
                  <c:pt idx="0">
                    <c:v>7.8671341739553022E-2</c:v>
                  </c:pt>
                  <c:pt idx="1">
                    <c:v>6.6966453814004512E-2</c:v>
                  </c:pt>
                  <c:pt idx="2">
                    <c:v>8.1559318928743102E-2</c:v>
                  </c:pt>
                  <c:pt idx="3">
                    <c:v>6.6069599669880449E-2</c:v>
                  </c:pt>
                </c:numCache>
              </c:numRef>
            </c:plus>
            <c:minus>
              <c:numRef>
                <c:f>Ube2O!$B$51:$E$51</c:f>
                <c:numCache>
                  <c:formatCode>General</c:formatCode>
                  <c:ptCount val="4"/>
                  <c:pt idx="0">
                    <c:v>7.8671341739553022E-2</c:v>
                  </c:pt>
                  <c:pt idx="1">
                    <c:v>6.6966453814004512E-2</c:v>
                  </c:pt>
                  <c:pt idx="2">
                    <c:v>8.1559318928743102E-2</c:v>
                  </c:pt>
                  <c:pt idx="3">
                    <c:v>6.6069599669880449E-2</c:v>
                  </c:pt>
                </c:numCache>
              </c:numRef>
            </c:minus>
          </c:errBars>
          <c:cat>
            <c:strRef>
              <c:f>Ube2O!$B$47:$E$47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Ube2O!$B$48:$E$48</c:f>
              <c:numCache>
                <c:formatCode>General</c:formatCode>
                <c:ptCount val="4"/>
                <c:pt idx="0">
                  <c:v>1</c:v>
                </c:pt>
                <c:pt idx="1">
                  <c:v>2.0115066403356523</c:v>
                </c:pt>
                <c:pt idx="2">
                  <c:v>1.8799324675649824</c:v>
                </c:pt>
                <c:pt idx="3">
                  <c:v>2.2392336054758264</c:v>
                </c:pt>
              </c:numCache>
            </c:numRef>
          </c:val>
        </c:ser>
        <c:ser>
          <c:idx val="1"/>
          <c:order val="1"/>
          <c:tx>
            <c:strRef>
              <c:f>Ube2O!$A$49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rgbClr val="993366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Ube2O!$B$52:$E$52</c:f>
                <c:numCache>
                  <c:formatCode>General</c:formatCode>
                  <c:ptCount val="4"/>
                  <c:pt idx="0">
                    <c:v>1.0932976093780085E-2</c:v>
                  </c:pt>
                  <c:pt idx="1">
                    <c:v>7.6093671970901819E-2</c:v>
                  </c:pt>
                  <c:pt idx="2">
                    <c:v>8.1111524066278168E-2</c:v>
                  </c:pt>
                  <c:pt idx="3">
                    <c:v>9.9102209293549154E-2</c:v>
                  </c:pt>
                </c:numCache>
              </c:numRef>
            </c:plus>
            <c:minus>
              <c:numRef>
                <c:f>Ube2O!$B$52:$E$52</c:f>
                <c:numCache>
                  <c:formatCode>General</c:formatCode>
                  <c:ptCount val="4"/>
                  <c:pt idx="0">
                    <c:v>1.0932976093780085E-2</c:v>
                  </c:pt>
                  <c:pt idx="1">
                    <c:v>7.6093671970901819E-2</c:v>
                  </c:pt>
                  <c:pt idx="2">
                    <c:v>8.1111524066278168E-2</c:v>
                  </c:pt>
                  <c:pt idx="3">
                    <c:v>9.9102209293549154E-2</c:v>
                  </c:pt>
                </c:numCache>
              </c:numRef>
            </c:minus>
          </c:errBars>
          <c:cat>
            <c:strRef>
              <c:f>Ube2O!$B$47:$E$47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Ube2O!$B$49:$E$49</c:f>
              <c:numCache>
                <c:formatCode>General</c:formatCode>
                <c:ptCount val="4"/>
                <c:pt idx="0">
                  <c:v>1.522058403481626</c:v>
                </c:pt>
                <c:pt idx="1">
                  <c:v>2.7584974102578332</c:v>
                </c:pt>
                <c:pt idx="2">
                  <c:v>2.3894857859498044</c:v>
                </c:pt>
                <c:pt idx="3">
                  <c:v>2.74612525818308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893824"/>
        <c:axId val="102895616"/>
      </c:barChart>
      <c:catAx>
        <c:axId val="10289382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02895616"/>
        <c:crosses val="autoZero"/>
        <c:auto val="1"/>
        <c:lblAlgn val="ctr"/>
        <c:lblOffset val="100"/>
        <c:noMultiLvlLbl val="0"/>
      </c:catAx>
      <c:valAx>
        <c:axId val="102895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02893824"/>
        <c:crosses val="autoZero"/>
        <c:crossBetween val="between"/>
        <c:majorUnit val="1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895494713460967"/>
          <c:y val="0.12206628734910206"/>
          <c:w val="0.50980554855222548"/>
          <c:h val="0.671364580420061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K&amp;TNRC6c'!$A$28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TK&amp;TNRC6c'!$B$31:$D$31</c:f>
                <c:numCache>
                  <c:formatCode>General</c:formatCode>
                  <c:ptCount val="3"/>
                  <c:pt idx="0">
                    <c:v>2.2566834630966079E-2</c:v>
                  </c:pt>
                  <c:pt idx="1">
                    <c:v>3.1901415842376317E-2</c:v>
                  </c:pt>
                  <c:pt idx="2">
                    <c:v>1.9336334360950568E-2</c:v>
                  </c:pt>
                </c:numCache>
              </c:numRef>
            </c:plus>
            <c:minus>
              <c:numRef>
                <c:f>'TK&amp;TNRC6c'!$B$31:$D$31</c:f>
                <c:numCache>
                  <c:formatCode>General</c:formatCode>
                  <c:ptCount val="3"/>
                  <c:pt idx="0">
                    <c:v>2.2566834630966079E-2</c:v>
                  </c:pt>
                  <c:pt idx="1">
                    <c:v>3.1901415842376317E-2</c:v>
                  </c:pt>
                  <c:pt idx="2">
                    <c:v>1.9336334360950568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TK&amp;TNRC6c'!$B$27:$D$27</c:f>
              <c:strCache>
                <c:ptCount val="3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</c:strCache>
            </c:strRef>
          </c:cat>
          <c:val>
            <c:numRef>
              <c:f>'TK&amp;TNRC6c'!$B$28:$D$28</c:f>
              <c:numCache>
                <c:formatCode>General</c:formatCode>
                <c:ptCount val="3"/>
                <c:pt idx="0">
                  <c:v>1.0000132429681636</c:v>
                </c:pt>
                <c:pt idx="1">
                  <c:v>0.75639168520241717</c:v>
                </c:pt>
                <c:pt idx="2">
                  <c:v>0.51083569014622343</c:v>
                </c:pt>
              </c:numCache>
            </c:numRef>
          </c:val>
        </c:ser>
        <c:ser>
          <c:idx val="1"/>
          <c:order val="1"/>
          <c:tx>
            <c:strRef>
              <c:f>'TK&amp;TNRC6c'!$A$29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rgbClr val="993366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TK&amp;TNRC6c'!$B$32:$D$32</c:f>
                <c:numCache>
                  <c:formatCode>General</c:formatCode>
                  <c:ptCount val="3"/>
                  <c:pt idx="0">
                    <c:v>8.4771853247569723E-2</c:v>
                  </c:pt>
                  <c:pt idx="1">
                    <c:v>4.1805418773429137E-2</c:v>
                  </c:pt>
                  <c:pt idx="2">
                    <c:v>4.9163666321913727E-2</c:v>
                  </c:pt>
                </c:numCache>
              </c:numRef>
            </c:plus>
            <c:minus>
              <c:numRef>
                <c:f>'TK&amp;TNRC6c'!$B$32:$D$32</c:f>
                <c:numCache>
                  <c:formatCode>General</c:formatCode>
                  <c:ptCount val="3"/>
                  <c:pt idx="0">
                    <c:v>8.4771853247569723E-2</c:v>
                  </c:pt>
                  <c:pt idx="1">
                    <c:v>4.1805418773429137E-2</c:v>
                  </c:pt>
                  <c:pt idx="2">
                    <c:v>4.9163666321913727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TK&amp;TNRC6c'!$B$27:$D$27</c:f>
              <c:strCache>
                <c:ptCount val="3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</c:strCache>
            </c:strRef>
          </c:cat>
          <c:val>
            <c:numRef>
              <c:f>'TK&amp;TNRC6c'!$B$29:$D$29</c:f>
              <c:numCache>
                <c:formatCode>General</c:formatCode>
                <c:ptCount val="3"/>
                <c:pt idx="0">
                  <c:v>1.5938636835760276</c:v>
                </c:pt>
                <c:pt idx="1">
                  <c:v>0.76733213710682457</c:v>
                </c:pt>
                <c:pt idx="2">
                  <c:v>0.568386436486617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929152"/>
        <c:axId val="102930688"/>
      </c:barChart>
      <c:catAx>
        <c:axId val="102929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93068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2930688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929152"/>
        <c:crosses val="autoZero"/>
        <c:crossBetween val="between"/>
        <c:majorUnit val="0.5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925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58712836114151"/>
          <c:y val="0.12500029343894006"/>
          <c:w val="0.52395286178550382"/>
          <c:h val="0.658655392351337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K&amp;TNRC6c'!$A$28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TK&amp;TNRC6c'!$B$31,'TK&amp;TNRC6c'!$E$31:$G$31)</c:f>
                <c:numCache>
                  <c:formatCode>General</c:formatCode>
                  <c:ptCount val="4"/>
                  <c:pt idx="0">
                    <c:v>2.2566834630966079E-2</c:v>
                  </c:pt>
                  <c:pt idx="1">
                    <c:v>5.2874315744753063E-2</c:v>
                  </c:pt>
                  <c:pt idx="2">
                    <c:v>0.15032996812658464</c:v>
                  </c:pt>
                  <c:pt idx="3">
                    <c:v>0.20305348948873897</c:v>
                  </c:pt>
                </c:numCache>
              </c:numRef>
            </c:plus>
            <c:minus>
              <c:numRef>
                <c:f>('TK&amp;TNRC6c'!$B$31,'TK&amp;TNRC6c'!$E$31:$G$31)</c:f>
                <c:numCache>
                  <c:formatCode>General</c:formatCode>
                  <c:ptCount val="4"/>
                  <c:pt idx="0">
                    <c:v>2.2566834630966079E-2</c:v>
                  </c:pt>
                  <c:pt idx="1">
                    <c:v>5.2874315744753063E-2</c:v>
                  </c:pt>
                  <c:pt idx="2">
                    <c:v>0.15032996812658464</c:v>
                  </c:pt>
                  <c:pt idx="3">
                    <c:v>0.20305348948873897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TK&amp;TNRC6c'!$B$27,'TK&amp;TNRC6c'!$E$27:$G$27)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('TK&amp;TNRC6c'!$B$28,'TK&amp;TNRC6c'!$E$28:$G$28)</c:f>
              <c:numCache>
                <c:formatCode>General</c:formatCode>
                <c:ptCount val="4"/>
                <c:pt idx="0">
                  <c:v>1.0000132429681636</c:v>
                </c:pt>
                <c:pt idx="1">
                  <c:v>0.73440622405408973</c:v>
                </c:pt>
                <c:pt idx="2">
                  <c:v>1.2352511502971413</c:v>
                </c:pt>
                <c:pt idx="3">
                  <c:v>1.2546819964396618</c:v>
                </c:pt>
              </c:numCache>
            </c:numRef>
          </c:val>
        </c:ser>
        <c:ser>
          <c:idx val="1"/>
          <c:order val="1"/>
          <c:tx>
            <c:strRef>
              <c:f>'TK&amp;TNRC6c'!$A$29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rgbClr val="993366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TK&amp;TNRC6c'!$B$32,'TK&amp;TNRC6c'!$E$32:$G$32)</c:f>
                <c:numCache>
                  <c:formatCode>General</c:formatCode>
                  <c:ptCount val="4"/>
                  <c:pt idx="0">
                    <c:v>8.4771853247569723E-2</c:v>
                  </c:pt>
                  <c:pt idx="1">
                    <c:v>3.128567319032384E-2</c:v>
                  </c:pt>
                  <c:pt idx="2">
                    <c:v>8.1719010676628873E-2</c:v>
                  </c:pt>
                  <c:pt idx="3">
                    <c:v>5.4597934302775562E-2</c:v>
                  </c:pt>
                </c:numCache>
              </c:numRef>
            </c:plus>
            <c:minus>
              <c:numRef>
                <c:f>('TK&amp;TNRC6c'!$B$32,'TK&amp;TNRC6c'!$E$32:$G$32)</c:f>
                <c:numCache>
                  <c:formatCode>General</c:formatCode>
                  <c:ptCount val="4"/>
                  <c:pt idx="0">
                    <c:v>8.4771853247569723E-2</c:v>
                  </c:pt>
                  <c:pt idx="1">
                    <c:v>3.128567319032384E-2</c:v>
                  </c:pt>
                  <c:pt idx="2">
                    <c:v>8.1719010676628873E-2</c:v>
                  </c:pt>
                  <c:pt idx="3">
                    <c:v>5.4597934302775562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TK&amp;TNRC6c'!$B$27,'TK&amp;TNRC6c'!$E$27:$G$27)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('TK&amp;TNRC6c'!$B$29,'TK&amp;TNRC6c'!$E$29:$G$29)</c:f>
              <c:numCache>
                <c:formatCode>General</c:formatCode>
                <c:ptCount val="4"/>
                <c:pt idx="0">
                  <c:v>1.5938636835760276</c:v>
                </c:pt>
                <c:pt idx="1">
                  <c:v>0.69635770318284296</c:v>
                </c:pt>
                <c:pt idx="2">
                  <c:v>0.84523583640814293</c:v>
                </c:pt>
                <c:pt idx="3">
                  <c:v>1.67418465745027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943744"/>
        <c:axId val="104084224"/>
      </c:barChart>
      <c:catAx>
        <c:axId val="102943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408422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40842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943744"/>
        <c:crosses val="autoZero"/>
        <c:crossBetween val="between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0"/>
            <c:dispEq val="0"/>
          </c:trendline>
          <c:trendline>
            <c:trendlineType val="linear"/>
            <c:dispRSqr val="1"/>
            <c:dispEq val="0"/>
            <c:trendlineLbl>
              <c:layout/>
              <c:numFmt formatCode="General" sourceLinked="0"/>
              <c:txPr>
                <a:bodyPr/>
                <a:lstStyle/>
                <a:p>
                  <a:pPr>
                    <a:defRPr/>
                  </a:pPr>
                  <a:endParaRPr lang="en-US"/>
                </a:p>
              </c:txPr>
            </c:trendlineLbl>
          </c:trendline>
          <c:xVal>
            <c:numRef>
              <c:f>Sheet2!$L$3:$L$31</c:f>
              <c:numCache>
                <c:formatCode>General</c:formatCode>
                <c:ptCount val="29"/>
                <c:pt idx="0">
                  <c:v>1.6429993333333357</c:v>
                </c:pt>
                <c:pt idx="4">
                  <c:v>1.463294833333336</c:v>
                </c:pt>
                <c:pt idx="8">
                  <c:v>2.2182456666666717</c:v>
                </c:pt>
                <c:pt idx="12">
                  <c:v>0.9588523333333363</c:v>
                </c:pt>
                <c:pt idx="16">
                  <c:v>1.7156939999999992</c:v>
                </c:pt>
                <c:pt idx="20">
                  <c:v>1.3841228333333326</c:v>
                </c:pt>
                <c:pt idx="24">
                  <c:v>1.6437676666666619</c:v>
                </c:pt>
                <c:pt idx="28">
                  <c:v>1.6960340000000009</c:v>
                </c:pt>
              </c:numCache>
            </c:numRef>
          </c:xVal>
          <c:yVal>
            <c:numRef>
              <c:f>Sheet2!$N$3:$N$31</c:f>
              <c:numCache>
                <c:formatCode>General</c:formatCode>
                <c:ptCount val="29"/>
                <c:pt idx="0">
                  <c:v>2.7623759999999962</c:v>
                </c:pt>
                <c:pt idx="4">
                  <c:v>4.851577666666671</c:v>
                </c:pt>
                <c:pt idx="8">
                  <c:v>0.76796833333333225</c:v>
                </c:pt>
                <c:pt idx="12">
                  <c:v>5.7183393333333399</c:v>
                </c:pt>
                <c:pt idx="16">
                  <c:v>4.0211989999999993</c:v>
                </c:pt>
                <c:pt idx="20">
                  <c:v>3.8733635000000035</c:v>
                </c:pt>
                <c:pt idx="24">
                  <c:v>3.6976240000000011</c:v>
                </c:pt>
                <c:pt idx="28">
                  <c:v>1.56770766666666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676096"/>
        <c:axId val="34768000"/>
      </c:scatterChart>
      <c:valAx>
        <c:axId val="34676096"/>
        <c:scaling>
          <c:orientation val="minMax"/>
          <c:min val="0.5"/>
        </c:scaling>
        <c:delete val="0"/>
        <c:axPos val="b"/>
        <c:numFmt formatCode="General" sourceLinked="1"/>
        <c:majorTickMark val="out"/>
        <c:minorTickMark val="none"/>
        <c:tickLblPos val="nextTo"/>
        <c:crossAx val="34768000"/>
        <c:crosses val="autoZero"/>
        <c:crossBetween val="midCat"/>
      </c:valAx>
      <c:valAx>
        <c:axId val="34768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467609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59</c:f>
              <c:strCache>
                <c:ptCount val="1"/>
              </c:strCache>
            </c:strRef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P$60:$P$62</c:f>
                <c:numCache>
                  <c:formatCode>General</c:formatCode>
                  <c:ptCount val="3"/>
                  <c:pt idx="0">
                    <c:v>0.13860711550991067</c:v>
                  </c:pt>
                  <c:pt idx="1">
                    <c:v>0.17</c:v>
                  </c:pt>
                  <c:pt idx="2">
                    <c:v>0.11502212370058718</c:v>
                  </c:pt>
                </c:numCache>
              </c:numRef>
            </c:plus>
            <c:minus>
              <c:numRef>
                <c:f>Sheet1!$Q$60:$Q$62</c:f>
                <c:numCache>
                  <c:formatCode>General</c:formatCode>
                  <c:ptCount val="3"/>
                  <c:pt idx="0">
                    <c:v>0.12173392702524721</c:v>
                  </c:pt>
                  <c:pt idx="1">
                    <c:v>0.14000000000000001</c:v>
                  </c:pt>
                  <c:pt idx="2">
                    <c:v>9.9909924459218535E-2</c:v>
                  </c:pt>
                </c:numCache>
              </c:numRef>
            </c:minus>
          </c:errBars>
          <c:cat>
            <c:numRef>
              <c:f>Sheet1!$N$60:$N$62</c:f>
              <c:numCache>
                <c:formatCode>General</c:formatCode>
                <c:ptCount val="3"/>
              </c:numCache>
            </c:numRef>
          </c:cat>
          <c:val>
            <c:numRef>
              <c:f>Sheet1!$O$60:$O$62</c:f>
              <c:numCache>
                <c:formatCode>0.0</c:formatCode>
                <c:ptCount val="3"/>
                <c:pt idx="0">
                  <c:v>1</c:v>
                </c:pt>
                <c:pt idx="1">
                  <c:v>1.0442811137018015</c:v>
                </c:pt>
                <c:pt idx="2">
                  <c:v>0.760435427466204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431104"/>
        <c:axId val="32436992"/>
      </c:barChart>
      <c:catAx>
        <c:axId val="32431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32436992"/>
        <c:crosses val="autoZero"/>
        <c:auto val="1"/>
        <c:lblAlgn val="ctr"/>
        <c:lblOffset val="100"/>
        <c:noMultiLvlLbl val="0"/>
      </c:catAx>
      <c:valAx>
        <c:axId val="32436992"/>
        <c:scaling>
          <c:orientation val="minMax"/>
          <c:min val="0"/>
        </c:scaling>
        <c:delete val="0"/>
        <c:axPos val="l"/>
        <c:numFmt formatCode="0.0" sourceLinked="1"/>
        <c:majorTickMark val="out"/>
        <c:minorTickMark val="none"/>
        <c:tickLblPos val="nextTo"/>
        <c:crossAx val="324311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25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/>
              <a:t>Glucose-free media</a:t>
            </a:r>
          </a:p>
        </c:rich>
      </c:tx>
      <c:layout>
        <c:manualLayout>
          <c:xMode val="edge"/>
          <c:yMode val="edge"/>
          <c:x val="0.35416756736136717"/>
          <c:y val="4.1152428756867108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5364622407588724"/>
          <c:y val="0.22633835816276912"/>
          <c:w val="0.80989789301018522"/>
          <c:h val="0.543212059590645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36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37:$E$39</c:f>
                <c:numCache>
                  <c:formatCode>General</c:formatCode>
                  <c:ptCount val="3"/>
                  <c:pt idx="0">
                    <c:v>0.90000000000000113</c:v>
                  </c:pt>
                  <c:pt idx="1">
                    <c:v>3.85</c:v>
                  </c:pt>
                  <c:pt idx="2">
                    <c:v>3.2</c:v>
                  </c:pt>
                </c:numCache>
              </c:numRef>
            </c:plus>
            <c:minus>
              <c:numRef>
                <c:f>Sheet1!$E$37:$E$39</c:f>
                <c:numCache>
                  <c:formatCode>General</c:formatCode>
                  <c:ptCount val="3"/>
                  <c:pt idx="0">
                    <c:v>0.90000000000000113</c:v>
                  </c:pt>
                  <c:pt idx="1">
                    <c:v>3.85</c:v>
                  </c:pt>
                  <c:pt idx="2">
                    <c:v>3.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37:$A$39</c:f>
              <c:strCache>
                <c:ptCount val="3"/>
                <c:pt idx="0">
                  <c:v>MycER-LacZ</c:v>
                </c:pt>
                <c:pt idx="1">
                  <c:v>MycER-JMJD6</c:v>
                </c:pt>
                <c:pt idx="2">
                  <c:v>MycER-JMJD6H187A</c:v>
                </c:pt>
              </c:strCache>
            </c:strRef>
          </c:cat>
          <c:val>
            <c:numRef>
              <c:f>Sheet1!$B$37:$B$39</c:f>
              <c:numCache>
                <c:formatCode>General</c:formatCode>
                <c:ptCount val="3"/>
                <c:pt idx="0">
                  <c:v>20.3</c:v>
                </c:pt>
                <c:pt idx="1">
                  <c:v>20.55</c:v>
                </c:pt>
                <c:pt idx="2">
                  <c:v>27.1</c:v>
                </c:pt>
              </c:numCache>
            </c:numRef>
          </c:val>
        </c:ser>
        <c:ser>
          <c:idx val="1"/>
          <c:order val="1"/>
          <c:tx>
            <c:strRef>
              <c:f>Sheet1!$C$36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37:$F$39</c:f>
                <c:numCache>
                  <c:formatCode>General</c:formatCode>
                  <c:ptCount val="3"/>
                  <c:pt idx="0">
                    <c:v>0.70000000000000639</c:v>
                  </c:pt>
                  <c:pt idx="1">
                    <c:v>2.4499999999999877</c:v>
                  </c:pt>
                  <c:pt idx="2">
                    <c:v>2.5500000000000105</c:v>
                  </c:pt>
                </c:numCache>
              </c:numRef>
            </c:plus>
            <c:minus>
              <c:numRef>
                <c:f>Sheet1!$F$37:$F$39</c:f>
                <c:numCache>
                  <c:formatCode>General</c:formatCode>
                  <c:ptCount val="3"/>
                  <c:pt idx="0">
                    <c:v>0.70000000000000639</c:v>
                  </c:pt>
                  <c:pt idx="1">
                    <c:v>2.4499999999999877</c:v>
                  </c:pt>
                  <c:pt idx="2">
                    <c:v>2.5500000000000105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37:$A$39</c:f>
              <c:strCache>
                <c:ptCount val="3"/>
                <c:pt idx="0">
                  <c:v>MycER-LacZ</c:v>
                </c:pt>
                <c:pt idx="1">
                  <c:v>MycER-JMJD6</c:v>
                </c:pt>
                <c:pt idx="2">
                  <c:v>MycER-JMJD6H187A</c:v>
                </c:pt>
              </c:strCache>
            </c:strRef>
          </c:cat>
          <c:val>
            <c:numRef>
              <c:f>Sheet1!$C$37:$C$39</c:f>
              <c:numCache>
                <c:formatCode>General</c:formatCode>
                <c:ptCount val="3"/>
                <c:pt idx="0">
                  <c:v>39</c:v>
                </c:pt>
                <c:pt idx="1">
                  <c:v>27.45</c:v>
                </c:pt>
                <c:pt idx="2">
                  <c:v>39.45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246080"/>
        <c:axId val="101247616"/>
      </c:barChart>
      <c:catAx>
        <c:axId val="1012460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24761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12476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8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% dead cells</a:t>
                </a:r>
              </a:p>
            </c:rich>
          </c:tx>
          <c:layout>
            <c:manualLayout>
              <c:xMode val="edge"/>
              <c:yMode val="edge"/>
              <c:x val="4.1666772630749083E-2"/>
              <c:y val="0.34979564443337047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246080"/>
        <c:crosses val="autoZero"/>
        <c:crossBetween val="between"/>
      </c:valAx>
      <c:spPr>
        <a:solidFill>
          <a:srgbClr val="C0C0C0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25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/>
              <a:t>Glutamin-free media</a:t>
            </a:r>
          </a:p>
        </c:rich>
      </c:tx>
      <c:layout>
        <c:manualLayout>
          <c:xMode val="edge"/>
          <c:yMode val="edge"/>
          <c:x val="0.34895922078252356"/>
          <c:y val="4.1152428756867108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5364622407588724"/>
          <c:y val="0.22633835816276912"/>
          <c:w val="0.80989789301018522"/>
          <c:h val="0.543212059590645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43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51:$E$53</c:f>
                <c:numCache>
                  <c:formatCode>General</c:formatCode>
                  <c:ptCount val="3"/>
                  <c:pt idx="0">
                    <c:v>2.75</c:v>
                  </c:pt>
                  <c:pt idx="1">
                    <c:v>1.85</c:v>
                  </c:pt>
                  <c:pt idx="2">
                    <c:v>2.5</c:v>
                  </c:pt>
                </c:numCache>
              </c:numRef>
            </c:plus>
            <c:minus>
              <c:numRef>
                <c:f>Sheet1!$E$51:$E$53</c:f>
                <c:numCache>
                  <c:formatCode>General</c:formatCode>
                  <c:ptCount val="3"/>
                  <c:pt idx="0">
                    <c:v>2.75</c:v>
                  </c:pt>
                  <c:pt idx="1">
                    <c:v>1.85</c:v>
                  </c:pt>
                  <c:pt idx="2">
                    <c:v>2.5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44:$A$46</c:f>
              <c:strCache>
                <c:ptCount val="3"/>
                <c:pt idx="0">
                  <c:v>MycER-LacZ</c:v>
                </c:pt>
                <c:pt idx="1">
                  <c:v>MycER-JMJD6</c:v>
                </c:pt>
                <c:pt idx="2">
                  <c:v>MycER-JMJD6H187A</c:v>
                </c:pt>
              </c:strCache>
            </c:strRef>
          </c:cat>
          <c:val>
            <c:numRef>
              <c:f>Sheet1!$B$44:$B$46</c:f>
              <c:numCache>
                <c:formatCode>General</c:formatCode>
                <c:ptCount val="3"/>
                <c:pt idx="0">
                  <c:v>18.579999999999998</c:v>
                </c:pt>
                <c:pt idx="1">
                  <c:v>16.725000000000001</c:v>
                </c:pt>
                <c:pt idx="2">
                  <c:v>26.504999999999999</c:v>
                </c:pt>
              </c:numCache>
            </c:numRef>
          </c:val>
        </c:ser>
        <c:ser>
          <c:idx val="1"/>
          <c:order val="1"/>
          <c:tx>
            <c:strRef>
              <c:f>Sheet1!$C$43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51:$F$53</c:f>
                <c:numCache>
                  <c:formatCode>General</c:formatCode>
                  <c:ptCount val="3"/>
                  <c:pt idx="0">
                    <c:v>0.7999999999999915</c:v>
                  </c:pt>
                  <c:pt idx="1">
                    <c:v>0.25</c:v>
                  </c:pt>
                  <c:pt idx="2">
                    <c:v>3.9</c:v>
                  </c:pt>
                </c:numCache>
              </c:numRef>
            </c:plus>
            <c:minus>
              <c:numRef>
                <c:f>Sheet1!$F$51:$F$53</c:f>
                <c:numCache>
                  <c:formatCode>General</c:formatCode>
                  <c:ptCount val="3"/>
                  <c:pt idx="0">
                    <c:v>0.7999999999999915</c:v>
                  </c:pt>
                  <c:pt idx="1">
                    <c:v>0.25</c:v>
                  </c:pt>
                  <c:pt idx="2">
                    <c:v>3.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44:$A$46</c:f>
              <c:strCache>
                <c:ptCount val="3"/>
                <c:pt idx="0">
                  <c:v>MycER-LacZ</c:v>
                </c:pt>
                <c:pt idx="1">
                  <c:v>MycER-JMJD6</c:v>
                </c:pt>
                <c:pt idx="2">
                  <c:v>MycER-JMJD6H187A</c:v>
                </c:pt>
              </c:strCache>
            </c:strRef>
          </c:cat>
          <c:val>
            <c:numRef>
              <c:f>Sheet1!$C$44:$C$46</c:f>
              <c:numCache>
                <c:formatCode>General</c:formatCode>
                <c:ptCount val="3"/>
                <c:pt idx="0">
                  <c:v>40.159999999999997</c:v>
                </c:pt>
                <c:pt idx="1">
                  <c:v>18.46</c:v>
                </c:pt>
                <c:pt idx="2">
                  <c:v>36.9799999999999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364096"/>
        <c:axId val="101365632"/>
      </c:barChart>
      <c:catAx>
        <c:axId val="101364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36563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136563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8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% dead cells</a:t>
                </a:r>
              </a:p>
            </c:rich>
          </c:tx>
          <c:layout>
            <c:manualLayout>
              <c:xMode val="edge"/>
              <c:yMode val="edge"/>
              <c:x val="4.1666772630749083E-2"/>
              <c:y val="0.34979564443337047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364096"/>
        <c:crosses val="autoZero"/>
        <c:crossBetween val="between"/>
      </c:valAx>
      <c:spPr>
        <a:solidFill>
          <a:srgbClr val="C0C0C0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25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/>
              <a:t>Etoposide</a:t>
            </a:r>
          </a:p>
        </c:rich>
      </c:tx>
      <c:layout>
        <c:manualLayout>
          <c:xMode val="edge"/>
          <c:yMode val="edge"/>
          <c:x val="0.42448024617575625"/>
          <c:y val="4.1152428756867108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5364622407588724"/>
          <c:y val="0.22633835816276912"/>
          <c:w val="0.80989789301018522"/>
          <c:h val="0.543212059590645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50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51:$E$53</c:f>
                <c:numCache>
                  <c:formatCode>General</c:formatCode>
                  <c:ptCount val="3"/>
                  <c:pt idx="0">
                    <c:v>2.75</c:v>
                  </c:pt>
                  <c:pt idx="1">
                    <c:v>1.85</c:v>
                  </c:pt>
                  <c:pt idx="2">
                    <c:v>2.5</c:v>
                  </c:pt>
                </c:numCache>
              </c:numRef>
            </c:plus>
            <c:minus>
              <c:numRef>
                <c:f>Sheet1!$E$51:$E$53</c:f>
                <c:numCache>
                  <c:formatCode>General</c:formatCode>
                  <c:ptCount val="3"/>
                  <c:pt idx="0">
                    <c:v>2.75</c:v>
                  </c:pt>
                  <c:pt idx="1">
                    <c:v>1.85</c:v>
                  </c:pt>
                  <c:pt idx="2">
                    <c:v>2.5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51:$A$53</c:f>
              <c:strCache>
                <c:ptCount val="3"/>
                <c:pt idx="0">
                  <c:v>MycER-LacZ</c:v>
                </c:pt>
                <c:pt idx="1">
                  <c:v>MycER-JMJD6</c:v>
                </c:pt>
                <c:pt idx="2">
                  <c:v>MycER-JMJD6H187A</c:v>
                </c:pt>
              </c:strCache>
            </c:strRef>
          </c:cat>
          <c:val>
            <c:numRef>
              <c:f>Sheet1!$B$51:$B$53</c:f>
              <c:numCache>
                <c:formatCode>General</c:formatCode>
                <c:ptCount val="3"/>
                <c:pt idx="0">
                  <c:v>5.05</c:v>
                </c:pt>
                <c:pt idx="1">
                  <c:v>6.25</c:v>
                </c:pt>
                <c:pt idx="2">
                  <c:v>2.8</c:v>
                </c:pt>
              </c:numCache>
            </c:numRef>
          </c:val>
        </c:ser>
        <c:ser>
          <c:idx val="1"/>
          <c:order val="1"/>
          <c:tx>
            <c:strRef>
              <c:f>Sheet1!$C$50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51:$F$53</c:f>
                <c:numCache>
                  <c:formatCode>General</c:formatCode>
                  <c:ptCount val="3"/>
                  <c:pt idx="0">
                    <c:v>0.7999999999999915</c:v>
                  </c:pt>
                  <c:pt idx="1">
                    <c:v>0.25</c:v>
                  </c:pt>
                  <c:pt idx="2">
                    <c:v>3.9</c:v>
                  </c:pt>
                </c:numCache>
              </c:numRef>
            </c:plus>
            <c:minus>
              <c:numRef>
                <c:f>Sheet1!$F$51:$F$53</c:f>
                <c:numCache>
                  <c:formatCode>General</c:formatCode>
                  <c:ptCount val="3"/>
                  <c:pt idx="0">
                    <c:v>0.7999999999999915</c:v>
                  </c:pt>
                  <c:pt idx="1">
                    <c:v>0.25</c:v>
                  </c:pt>
                  <c:pt idx="2">
                    <c:v>3.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A$51:$A$53</c:f>
              <c:strCache>
                <c:ptCount val="3"/>
                <c:pt idx="0">
                  <c:v>MycER-LacZ</c:v>
                </c:pt>
                <c:pt idx="1">
                  <c:v>MycER-JMJD6</c:v>
                </c:pt>
                <c:pt idx="2">
                  <c:v>MycER-JMJD6H187A</c:v>
                </c:pt>
              </c:strCache>
            </c:strRef>
          </c:cat>
          <c:val>
            <c:numRef>
              <c:f>Sheet1!$C$51:$C$53</c:f>
              <c:numCache>
                <c:formatCode>General</c:formatCode>
                <c:ptCount val="3"/>
                <c:pt idx="0">
                  <c:v>28.7</c:v>
                </c:pt>
                <c:pt idx="1">
                  <c:v>19.649999999999999</c:v>
                </c:pt>
                <c:pt idx="2">
                  <c:v>26.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399936"/>
        <c:axId val="101401728"/>
      </c:barChart>
      <c:catAx>
        <c:axId val="101399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40172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14017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8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% dead cells</a:t>
                </a:r>
              </a:p>
            </c:rich>
          </c:tx>
          <c:layout>
            <c:manualLayout>
              <c:xMode val="edge"/>
              <c:yMode val="edge"/>
              <c:x val="4.1666772630749083E-2"/>
              <c:y val="0.34979564443337047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399936"/>
        <c:crosses val="autoZero"/>
        <c:crossBetween val="between"/>
      </c:valAx>
      <c:spPr>
        <a:solidFill>
          <a:srgbClr val="C0C0C0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475605779859559"/>
          <c:y val="0.10924392160402771"/>
          <c:w val="0.72964285430268716"/>
          <c:h val="0.701682111841254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BF1'!$F$51:$I$51</c:f>
                <c:numCache>
                  <c:formatCode>General</c:formatCode>
                  <c:ptCount val="4"/>
                  <c:pt idx="0">
                    <c:v>3.205892478755977E-2</c:v>
                  </c:pt>
                  <c:pt idx="1">
                    <c:v>2.8325492864718577E-3</c:v>
                  </c:pt>
                  <c:pt idx="2">
                    <c:v>1.3192650139754264E-2</c:v>
                  </c:pt>
                  <c:pt idx="3">
                    <c:v>5.058990670475056E-2</c:v>
                  </c:pt>
                </c:numCache>
              </c:numRef>
            </c:plus>
            <c:minus>
              <c:numRef>
                <c:f>'FBF1'!$F$51:$I$51</c:f>
                <c:numCache>
                  <c:formatCode>General</c:formatCode>
                  <c:ptCount val="4"/>
                  <c:pt idx="0">
                    <c:v>3.205892478755977E-2</c:v>
                  </c:pt>
                  <c:pt idx="1">
                    <c:v>2.8325492864718577E-3</c:v>
                  </c:pt>
                  <c:pt idx="2">
                    <c:v>1.3192650139754264E-2</c:v>
                  </c:pt>
                  <c:pt idx="3">
                    <c:v>5.058990670475056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FBF1'!$F$47:$I$47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'FBF1'!$F$48:$I$48</c:f>
              <c:numCache>
                <c:formatCode>General</c:formatCode>
                <c:ptCount val="4"/>
                <c:pt idx="0">
                  <c:v>1.0000992450340789</c:v>
                </c:pt>
                <c:pt idx="1">
                  <c:v>0.35373121918070022</c:v>
                </c:pt>
                <c:pt idx="2">
                  <c:v>0.296632368298961</c:v>
                </c:pt>
                <c:pt idx="3">
                  <c:v>1.16323535497683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223872"/>
        <c:axId val="102225408"/>
      </c:barChart>
      <c:catAx>
        <c:axId val="102223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22540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2225408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223872"/>
        <c:crosses val="autoZero"/>
        <c:crossBetween val="between"/>
        <c:majorUnit val="0.5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475605779859559"/>
          <c:y val="0.11304347826086956"/>
          <c:w val="0.72964285430268716"/>
          <c:h val="0.691304347826086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Birc&amp;Sumo'!$K$63,'Birc&amp;Sumo'!$O$63:$Q$63)</c:f>
                <c:numCache>
                  <c:formatCode>General</c:formatCode>
                  <c:ptCount val="4"/>
                  <c:pt idx="0">
                    <c:v>5.7115046778150616E-2</c:v>
                  </c:pt>
                  <c:pt idx="1">
                    <c:v>0.21833372538430845</c:v>
                  </c:pt>
                  <c:pt idx="2">
                    <c:v>0.30327049977052206</c:v>
                  </c:pt>
                  <c:pt idx="3">
                    <c:v>8.6924881866464451E-2</c:v>
                  </c:pt>
                </c:numCache>
              </c:numRef>
            </c:plus>
            <c:minus>
              <c:numRef>
                <c:f>('Birc&amp;Sumo'!$K$63,'Birc&amp;Sumo'!$O$63:$Q$63)</c:f>
                <c:numCache>
                  <c:formatCode>General</c:formatCode>
                  <c:ptCount val="4"/>
                  <c:pt idx="0">
                    <c:v>5.7115046778150616E-2</c:v>
                  </c:pt>
                  <c:pt idx="1">
                    <c:v>0.21833372538430845</c:v>
                  </c:pt>
                  <c:pt idx="2">
                    <c:v>0.30327049977052206</c:v>
                  </c:pt>
                  <c:pt idx="3">
                    <c:v>8.6924881866464451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Birc&amp;Sumo'!$K$60,'Birc&amp;Sumo'!$O$60:$Q$60)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('Birc&amp;Sumo'!$K$61,'Birc&amp;Sumo'!$O$61:$Q$61)</c:f>
              <c:numCache>
                <c:formatCode>General</c:formatCode>
                <c:ptCount val="4"/>
                <c:pt idx="0">
                  <c:v>1.0000751171974647</c:v>
                </c:pt>
                <c:pt idx="1">
                  <c:v>2.8997894251663205</c:v>
                </c:pt>
                <c:pt idx="2">
                  <c:v>2.28521649383022</c:v>
                </c:pt>
                <c:pt idx="3">
                  <c:v>2.46914974313615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143104"/>
        <c:axId val="102144640"/>
      </c:barChart>
      <c:catAx>
        <c:axId val="102143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14464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2144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143104"/>
        <c:crosses val="autoZero"/>
        <c:crossBetween val="between"/>
        <c:majorUnit val="1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Ube2O!$I$49:$L$49</c:f>
                <c:numCache>
                  <c:formatCode>General</c:formatCode>
                  <c:ptCount val="4"/>
                  <c:pt idx="0">
                    <c:v>5.9431697053536917E-2</c:v>
                  </c:pt>
                  <c:pt idx="1">
                    <c:v>0.35732125711433682</c:v>
                  </c:pt>
                  <c:pt idx="2">
                    <c:v>8.5867873743765422E-3</c:v>
                  </c:pt>
                  <c:pt idx="3">
                    <c:v>4.0920072254538392E-2</c:v>
                  </c:pt>
                </c:numCache>
              </c:numRef>
            </c:plus>
            <c:minus>
              <c:numRef>
                <c:f>Ube2O!$I$49:$L$49</c:f>
                <c:numCache>
                  <c:formatCode>General</c:formatCode>
                  <c:ptCount val="4"/>
                  <c:pt idx="0">
                    <c:v>5.9431697053536917E-2</c:v>
                  </c:pt>
                  <c:pt idx="1">
                    <c:v>0.35732125711433682</c:v>
                  </c:pt>
                  <c:pt idx="2">
                    <c:v>8.5867873743765422E-3</c:v>
                  </c:pt>
                  <c:pt idx="3">
                    <c:v>4.0920072254538392E-2</c:v>
                  </c:pt>
                </c:numCache>
              </c:numRef>
            </c:minus>
          </c:errBars>
          <c:cat>
            <c:strRef>
              <c:f>Ube2O!$I$47:$L$47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Ube2O!$I$48:$L$48</c:f>
              <c:numCache>
                <c:formatCode>General</c:formatCode>
                <c:ptCount val="4"/>
                <c:pt idx="0">
                  <c:v>1</c:v>
                </c:pt>
                <c:pt idx="1">
                  <c:v>2.2593438770455458</c:v>
                </c:pt>
                <c:pt idx="2">
                  <c:v>0.6457043088739054</c:v>
                </c:pt>
                <c:pt idx="3">
                  <c:v>1.29597333586524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152448"/>
        <c:axId val="101715968"/>
      </c:barChart>
      <c:catAx>
        <c:axId val="10215244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01715968"/>
        <c:crosses val="autoZero"/>
        <c:auto val="1"/>
        <c:lblAlgn val="ctr"/>
        <c:lblOffset val="100"/>
        <c:noMultiLvlLbl val="0"/>
      </c:catAx>
      <c:valAx>
        <c:axId val="1017159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02152448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295774647887325"/>
          <c:y val="0.12935386229915996"/>
          <c:w val="0.70774647887323938"/>
          <c:h val="0.6467693114957997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TK&amp;TNRC6c'!$J$30:$L$30</c:f>
                <c:numCache>
                  <c:formatCode>General</c:formatCode>
                  <c:ptCount val="3"/>
                  <c:pt idx="0">
                    <c:v>0.1026687697532751</c:v>
                  </c:pt>
                  <c:pt idx="1">
                    <c:v>3.7934424169122231E-2</c:v>
                  </c:pt>
                  <c:pt idx="2">
                    <c:v>0.15310115276137554</c:v>
                  </c:pt>
                </c:numCache>
              </c:numRef>
            </c:plus>
            <c:minus>
              <c:numRef>
                <c:f>'TK&amp;TNRC6c'!$J$30:$L$30</c:f>
                <c:numCache>
                  <c:formatCode>General</c:formatCode>
                  <c:ptCount val="3"/>
                  <c:pt idx="0">
                    <c:v>0.1026687697532751</c:v>
                  </c:pt>
                  <c:pt idx="1">
                    <c:v>3.7934424169122231E-2</c:v>
                  </c:pt>
                  <c:pt idx="2">
                    <c:v>0.15310115276137554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TK&amp;TNRC6c'!$J$27:$L$27</c:f>
              <c:strCache>
                <c:ptCount val="3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</c:strCache>
            </c:strRef>
          </c:cat>
          <c:val>
            <c:numRef>
              <c:f>'TK&amp;TNRC6c'!$J$28:$L$28</c:f>
              <c:numCache>
                <c:formatCode>General</c:formatCode>
                <c:ptCount val="3"/>
                <c:pt idx="0">
                  <c:v>1.0000016026219649</c:v>
                </c:pt>
                <c:pt idx="1">
                  <c:v>0.71179701997409717</c:v>
                </c:pt>
                <c:pt idx="2">
                  <c:v>1.55238961078554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723520"/>
        <c:axId val="101745792"/>
      </c:barChart>
      <c:catAx>
        <c:axId val="101723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74579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1745792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723520"/>
        <c:crosses val="autoZero"/>
        <c:crossBetween val="between"/>
        <c:majorUnit val="0.5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58414572532052"/>
          <c:y val="0.13541735543495401"/>
          <c:w val="0.71180796918392331"/>
          <c:h val="0.6302115387549781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TK&amp;TNRC6c'!$J$30,'TK&amp;TNRC6c'!$M$30:$O$30)</c:f>
                <c:numCache>
                  <c:formatCode>General</c:formatCode>
                  <c:ptCount val="4"/>
                  <c:pt idx="0">
                    <c:v>0.1026687697532751</c:v>
                  </c:pt>
                  <c:pt idx="1">
                    <c:v>5.2046102240596512E-2</c:v>
                  </c:pt>
                  <c:pt idx="2">
                    <c:v>2.4267569659797456E-2</c:v>
                  </c:pt>
                  <c:pt idx="3">
                    <c:v>5.3087145875036719E-2</c:v>
                  </c:pt>
                </c:numCache>
              </c:numRef>
            </c:plus>
            <c:minus>
              <c:numRef>
                <c:f>('TK&amp;TNRC6c'!$J$30,'TK&amp;TNRC6c'!$M$30:$O$30)</c:f>
                <c:numCache>
                  <c:formatCode>General</c:formatCode>
                  <c:ptCount val="4"/>
                  <c:pt idx="0">
                    <c:v>0.1026687697532751</c:v>
                  </c:pt>
                  <c:pt idx="1">
                    <c:v>5.2046102240596512E-2</c:v>
                  </c:pt>
                  <c:pt idx="2">
                    <c:v>2.4267569659797456E-2</c:v>
                  </c:pt>
                  <c:pt idx="3">
                    <c:v>5.3087145875036719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TK&amp;TNRC6c'!$J$27,'TK&amp;TNRC6c'!$M$27:$O$27)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('TK&amp;TNRC6c'!$J$28,'TK&amp;TNRC6c'!$M$28:$O$28)</c:f>
              <c:numCache>
                <c:formatCode>General</c:formatCode>
                <c:ptCount val="4"/>
                <c:pt idx="0">
                  <c:v>1.0000016026219649</c:v>
                </c:pt>
                <c:pt idx="1">
                  <c:v>1.0518222472725771</c:v>
                </c:pt>
                <c:pt idx="2">
                  <c:v>0.888551785191393</c:v>
                </c:pt>
                <c:pt idx="3">
                  <c:v>1.19202016896908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765888"/>
        <c:axId val="101767424"/>
      </c:barChart>
      <c:catAx>
        <c:axId val="101765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76742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1767424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1765888"/>
        <c:crosses val="autoZero"/>
        <c:crossBetween val="between"/>
        <c:majorUnit val="0.5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871832110957811"/>
          <c:y val="0.23673469387755103"/>
          <c:w val="0.62051437428479139"/>
          <c:h val="0.5795918367346938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BF1'!$G$39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BF1'!$H$42:$K$42</c:f>
                <c:numCache>
                  <c:formatCode>General</c:formatCode>
                  <c:ptCount val="4"/>
                  <c:pt idx="0">
                    <c:v>5.3042397492333394E-2</c:v>
                  </c:pt>
                  <c:pt idx="1">
                    <c:v>5.8135893296122072E-2</c:v>
                  </c:pt>
                  <c:pt idx="2">
                    <c:v>9.4503747377817776E-2</c:v>
                  </c:pt>
                  <c:pt idx="3">
                    <c:v>2.1732535229349561E-2</c:v>
                  </c:pt>
                </c:numCache>
              </c:numRef>
            </c:plus>
            <c:minus>
              <c:numRef>
                <c:f>'FBF1'!$H$42:$K$42</c:f>
                <c:numCache>
                  <c:formatCode>General</c:formatCode>
                  <c:ptCount val="4"/>
                  <c:pt idx="0">
                    <c:v>5.3042397492333394E-2</c:v>
                  </c:pt>
                  <c:pt idx="1">
                    <c:v>5.8135893296122072E-2</c:v>
                  </c:pt>
                  <c:pt idx="2">
                    <c:v>9.4503747377817776E-2</c:v>
                  </c:pt>
                  <c:pt idx="3">
                    <c:v>2.1732535229349561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FBF1'!$H$38:$K$38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'FBF1'!$H$39:$K$39</c:f>
              <c:numCache>
                <c:formatCode>General</c:formatCode>
                <c:ptCount val="4"/>
                <c:pt idx="0">
                  <c:v>0.99992811930592218</c:v>
                </c:pt>
                <c:pt idx="1">
                  <c:v>0.86726086290710813</c:v>
                </c:pt>
                <c:pt idx="2">
                  <c:v>1.2197615805257189</c:v>
                </c:pt>
                <c:pt idx="3">
                  <c:v>0.83128815952289881</c:v>
                </c:pt>
              </c:numCache>
            </c:numRef>
          </c:val>
        </c:ser>
        <c:ser>
          <c:idx val="1"/>
          <c:order val="1"/>
          <c:tx>
            <c:strRef>
              <c:f>'FBF1'!$G$40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rgbClr val="993366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BF1'!$H$43:$K$43</c:f>
                <c:numCache>
                  <c:formatCode>General</c:formatCode>
                  <c:ptCount val="4"/>
                  <c:pt idx="0">
                    <c:v>4.2385229019105394E-2</c:v>
                  </c:pt>
                  <c:pt idx="1">
                    <c:v>4.2047154103206898E-2</c:v>
                  </c:pt>
                  <c:pt idx="2">
                    <c:v>0.11675682260082594</c:v>
                  </c:pt>
                  <c:pt idx="3">
                    <c:v>8.2904214047385613E-2</c:v>
                  </c:pt>
                </c:numCache>
              </c:numRef>
            </c:plus>
            <c:minus>
              <c:numRef>
                <c:f>'FBF1'!$H$43:$K$43</c:f>
                <c:numCache>
                  <c:formatCode>General</c:formatCode>
                  <c:ptCount val="4"/>
                  <c:pt idx="0">
                    <c:v>4.2385229019105394E-2</c:v>
                  </c:pt>
                  <c:pt idx="1">
                    <c:v>4.2047154103206898E-2</c:v>
                  </c:pt>
                  <c:pt idx="2">
                    <c:v>0.11675682260082594</c:v>
                  </c:pt>
                  <c:pt idx="3">
                    <c:v>8.2904214047385613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FBF1'!$H$38:$K$38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'FBF1'!$H$40:$K$40</c:f>
              <c:numCache>
                <c:formatCode>General</c:formatCode>
                <c:ptCount val="4"/>
                <c:pt idx="0">
                  <c:v>1.5353983810646883</c:v>
                </c:pt>
                <c:pt idx="1">
                  <c:v>2.0842930740012662</c:v>
                </c:pt>
                <c:pt idx="2">
                  <c:v>3.245424277762071</c:v>
                </c:pt>
                <c:pt idx="3">
                  <c:v>2.22848275025093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255616"/>
        <c:axId val="102261504"/>
      </c:barChart>
      <c:catAx>
        <c:axId val="102255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26150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2261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255616"/>
        <c:crosses val="autoZero"/>
        <c:crossBetween val="between"/>
        <c:majorUnit val="1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22100652014827"/>
          <c:y val="0.10526336598432356"/>
          <c:w val="0.58701373150077552"/>
          <c:h val="0.712552015893882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irc&amp;Sumo'!$A$61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Birc&amp;Sumo'!$B$64:$E$64</c:f>
                <c:numCache>
                  <c:formatCode>General</c:formatCode>
                  <c:ptCount val="4"/>
                  <c:pt idx="0">
                    <c:v>6.3572614692628607E-2</c:v>
                  </c:pt>
                  <c:pt idx="1">
                    <c:v>6.6484489949492406E-3</c:v>
                  </c:pt>
                  <c:pt idx="2">
                    <c:v>1.3866668195612396E-2</c:v>
                  </c:pt>
                  <c:pt idx="3">
                    <c:v>2.3038979005316953E-2</c:v>
                  </c:pt>
                </c:numCache>
              </c:numRef>
            </c:plus>
            <c:minus>
              <c:numRef>
                <c:f>'Birc&amp;Sumo'!$B$64:$E$64</c:f>
                <c:numCache>
                  <c:formatCode>General</c:formatCode>
                  <c:ptCount val="4"/>
                  <c:pt idx="0">
                    <c:v>6.3572614692628607E-2</c:v>
                  </c:pt>
                  <c:pt idx="1">
                    <c:v>6.6484489949492406E-3</c:v>
                  </c:pt>
                  <c:pt idx="2">
                    <c:v>1.3866668195612396E-2</c:v>
                  </c:pt>
                  <c:pt idx="3">
                    <c:v>2.3038979005316953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Birc&amp;Sumo'!$B$60:$E$60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'Birc&amp;Sumo'!$B$61:$E$61</c:f>
              <c:numCache>
                <c:formatCode>General</c:formatCode>
                <c:ptCount val="4"/>
                <c:pt idx="0">
                  <c:v>1.0002906202920525</c:v>
                </c:pt>
                <c:pt idx="1">
                  <c:v>0.42970859838117476</c:v>
                </c:pt>
                <c:pt idx="2">
                  <c:v>0.41809550159271941</c:v>
                </c:pt>
                <c:pt idx="3">
                  <c:v>0.59538351560414926</c:v>
                </c:pt>
              </c:numCache>
            </c:numRef>
          </c:val>
        </c:ser>
        <c:ser>
          <c:idx val="1"/>
          <c:order val="1"/>
          <c:tx>
            <c:strRef>
              <c:f>'Birc&amp;Sumo'!$A$62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rgbClr val="993366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Birc&amp;Sumo'!$B$65:$E$65</c:f>
                <c:numCache>
                  <c:formatCode>General</c:formatCode>
                  <c:ptCount val="4"/>
                  <c:pt idx="0">
                    <c:v>0.13325157121571168</c:v>
                  </c:pt>
                  <c:pt idx="1">
                    <c:v>1.3335164522253954E-2</c:v>
                  </c:pt>
                  <c:pt idx="2">
                    <c:v>1.7681995931483074E-2</c:v>
                  </c:pt>
                  <c:pt idx="3">
                    <c:v>0.14665935638524333</c:v>
                  </c:pt>
                </c:numCache>
              </c:numRef>
            </c:plus>
            <c:minus>
              <c:numRef>
                <c:f>'Birc&amp;Sumo'!$B$65:$E$65</c:f>
                <c:numCache>
                  <c:formatCode>General</c:formatCode>
                  <c:ptCount val="4"/>
                  <c:pt idx="0">
                    <c:v>0.13325157121571168</c:v>
                  </c:pt>
                  <c:pt idx="1">
                    <c:v>1.3335164522253954E-2</c:v>
                  </c:pt>
                  <c:pt idx="2">
                    <c:v>1.7681995931483074E-2</c:v>
                  </c:pt>
                  <c:pt idx="3">
                    <c:v>0.14665935638524333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Birc&amp;Sumo'!$B$60:$E$60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'Birc&amp;Sumo'!$B$62:$E$62</c:f>
              <c:numCache>
                <c:formatCode>General</c:formatCode>
                <c:ptCount val="4"/>
                <c:pt idx="0">
                  <c:v>1.7304043180697708</c:v>
                </c:pt>
                <c:pt idx="1">
                  <c:v>0.4005234795233486</c:v>
                </c:pt>
                <c:pt idx="2">
                  <c:v>0.51092777992621574</c:v>
                </c:pt>
                <c:pt idx="3">
                  <c:v>0.809405206436018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299136"/>
        <c:axId val="102300672"/>
      </c:barChart>
      <c:catAx>
        <c:axId val="10229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30067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2300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299136"/>
        <c:crosses val="autoZero"/>
        <c:crossBetween val="between"/>
        <c:majorUnit val="0.5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22100652014827"/>
          <c:y val="0.10569147648102643"/>
          <c:w val="0.58701373150077552"/>
          <c:h val="0.711384937853062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irc&amp;Sumo'!$A$61</c:f>
              <c:strCache>
                <c:ptCount val="1"/>
                <c:pt idx="0">
                  <c:v>MycOFF</c:v>
                </c:pt>
              </c:strCache>
            </c:strRef>
          </c:tx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Birc&amp;Sumo'!$B$64,'Birc&amp;Sumo'!$F$64:$H$64)</c:f>
                <c:numCache>
                  <c:formatCode>General</c:formatCode>
                  <c:ptCount val="4"/>
                  <c:pt idx="0">
                    <c:v>6.3572614692628607E-2</c:v>
                  </c:pt>
                  <c:pt idx="1">
                    <c:v>3.5556349157237301E-2</c:v>
                  </c:pt>
                  <c:pt idx="2">
                    <c:v>1.8108789649864763E-2</c:v>
                  </c:pt>
                  <c:pt idx="3">
                    <c:v>5.6978507530843901E-2</c:v>
                  </c:pt>
                </c:numCache>
              </c:numRef>
            </c:plus>
            <c:minus>
              <c:numRef>
                <c:f>('Birc&amp;Sumo'!$B$64,'Birc&amp;Sumo'!$F$64:$H$64)</c:f>
                <c:numCache>
                  <c:formatCode>General</c:formatCode>
                  <c:ptCount val="4"/>
                  <c:pt idx="0">
                    <c:v>6.3572614692628607E-2</c:v>
                  </c:pt>
                  <c:pt idx="1">
                    <c:v>3.5556349157237301E-2</c:v>
                  </c:pt>
                  <c:pt idx="2">
                    <c:v>1.8108789649864763E-2</c:v>
                  </c:pt>
                  <c:pt idx="3">
                    <c:v>5.6978507530843901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Birc&amp;Sumo'!$B$60,'Birc&amp;Sumo'!$F$60:$H$60)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('Birc&amp;Sumo'!$B$61,'Birc&amp;Sumo'!$F$61:$H$61)</c:f>
              <c:numCache>
                <c:formatCode>General</c:formatCode>
                <c:ptCount val="4"/>
                <c:pt idx="0">
                  <c:v>1.0002906202920525</c:v>
                </c:pt>
                <c:pt idx="1">
                  <c:v>0.63735129437412541</c:v>
                </c:pt>
                <c:pt idx="2">
                  <c:v>0.5804048106456301</c:v>
                </c:pt>
                <c:pt idx="3">
                  <c:v>0.6778408461679748</c:v>
                </c:pt>
              </c:numCache>
            </c:numRef>
          </c:val>
        </c:ser>
        <c:ser>
          <c:idx val="1"/>
          <c:order val="1"/>
          <c:tx>
            <c:strRef>
              <c:f>'Birc&amp;Sumo'!$A$62</c:f>
              <c:strCache>
                <c:ptCount val="1"/>
                <c:pt idx="0">
                  <c:v>MycON</c:v>
                </c:pt>
              </c:strCache>
            </c:strRef>
          </c:tx>
          <c:spPr>
            <a:solidFill>
              <a:srgbClr val="993366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Birc&amp;Sumo'!$B$65,'Birc&amp;Sumo'!$F$65:$H$65)</c:f>
                <c:numCache>
                  <c:formatCode>General</c:formatCode>
                  <c:ptCount val="4"/>
                  <c:pt idx="0">
                    <c:v>0.13325157121571168</c:v>
                  </c:pt>
                  <c:pt idx="1">
                    <c:v>4.8831440887555651E-2</c:v>
                  </c:pt>
                  <c:pt idx="2">
                    <c:v>4.8053969613584949E-2</c:v>
                  </c:pt>
                  <c:pt idx="3">
                    <c:v>7.3354167050379629E-2</c:v>
                  </c:pt>
                </c:numCache>
              </c:numRef>
            </c:plus>
            <c:minus>
              <c:numRef>
                <c:f>('Birc&amp;Sumo'!$B$65,'Birc&amp;Sumo'!$F$65:$H$65)</c:f>
                <c:numCache>
                  <c:formatCode>General</c:formatCode>
                  <c:ptCount val="4"/>
                  <c:pt idx="0">
                    <c:v>0.13325157121571168</c:v>
                  </c:pt>
                  <c:pt idx="1">
                    <c:v>4.8831440887555651E-2</c:v>
                  </c:pt>
                  <c:pt idx="2">
                    <c:v>4.8053969613584949E-2</c:v>
                  </c:pt>
                  <c:pt idx="3">
                    <c:v>7.3354167050379629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Birc&amp;Sumo'!$B$60,'Birc&amp;Sumo'!$F$60:$H$60)</c:f>
              <c:strCache>
                <c:ptCount val="4"/>
                <c:pt idx="0">
                  <c:v>EV</c:v>
                </c:pt>
                <c:pt idx="1">
                  <c:v>sh1</c:v>
                </c:pt>
                <c:pt idx="2">
                  <c:v>sh2</c:v>
                </c:pt>
                <c:pt idx="3">
                  <c:v>sh3</c:v>
                </c:pt>
              </c:strCache>
            </c:strRef>
          </c:cat>
          <c:val>
            <c:numRef>
              <c:f>('Birc&amp;Sumo'!$B$62,'Birc&amp;Sumo'!$F$62:$H$62)</c:f>
              <c:numCache>
                <c:formatCode>General</c:formatCode>
                <c:ptCount val="4"/>
                <c:pt idx="0">
                  <c:v>1.7304043180697708</c:v>
                </c:pt>
                <c:pt idx="1">
                  <c:v>0.60355005207964585</c:v>
                </c:pt>
                <c:pt idx="2">
                  <c:v>0.56271247459923768</c:v>
                </c:pt>
                <c:pt idx="3">
                  <c:v>0.686213539835513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604800"/>
        <c:axId val="102606336"/>
      </c:barChart>
      <c:catAx>
        <c:axId val="102604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60633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02606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2604800"/>
        <c:crosses val="autoZero"/>
        <c:crossBetween val="between"/>
        <c:majorUnit val="0.5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image" Target="../media/image6.png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png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image" Target="../media/image15.png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657D8B-79A4-479D-BB9B-4B26930DD7DB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298FF5-2ADD-49CF-972E-1EDD2CAD6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912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384E7C-1A5D-46BE-AACD-3622084FDF3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9348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384E7C-1A5D-46BE-AACD-3622084FDF3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2806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384E7C-1A5D-46BE-AACD-3622084FDF3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3274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384E7C-1A5D-46BE-AACD-3622084FDF3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82352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384E7C-1A5D-46BE-AACD-3622084FDF3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7359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46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88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674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694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584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051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622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859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0764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979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404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6B2810-8DED-4EEE-AB23-7A77E77D5A03}" type="datetimeFigureOut">
              <a:rPr lang="en-US" smtClean="0"/>
              <a:t>4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B3CB5C-9BC7-4B63-B8F4-7BE84C4D8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861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10" Type="http://schemas.openxmlformats.org/officeDocument/2006/relationships/image" Target="../media/image5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8.png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6.png"/><Relationship Id="rId4" Type="http://schemas.openxmlformats.org/officeDocument/2006/relationships/oleObject" Target="../embeddings/oleObject3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1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19.png"/><Relationship Id="rId18" Type="http://schemas.openxmlformats.org/officeDocument/2006/relationships/image" Target="../media/image22.png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16.png"/><Relationship Id="rId12" Type="http://schemas.openxmlformats.org/officeDocument/2006/relationships/oleObject" Target="../embeddings/oleObject10.bin"/><Relationship Id="rId17" Type="http://schemas.openxmlformats.org/officeDocument/2006/relationships/image" Target="../media/image21.png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2.bin"/><Relationship Id="rId20" Type="http://schemas.openxmlformats.org/officeDocument/2006/relationships/image" Target="../media/image24.png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8.png"/><Relationship Id="rId5" Type="http://schemas.openxmlformats.org/officeDocument/2006/relationships/image" Target="../media/image15.png"/><Relationship Id="rId15" Type="http://schemas.openxmlformats.org/officeDocument/2006/relationships/image" Target="../media/image20.png"/><Relationship Id="rId10" Type="http://schemas.openxmlformats.org/officeDocument/2006/relationships/oleObject" Target="../embeddings/oleObject9.bin"/><Relationship Id="rId19" Type="http://schemas.openxmlformats.org/officeDocument/2006/relationships/image" Target="../media/image23.png"/><Relationship Id="rId4" Type="http://schemas.openxmlformats.org/officeDocument/2006/relationships/oleObject" Target="../embeddings/oleObject6.bin"/><Relationship Id="rId9" Type="http://schemas.openxmlformats.org/officeDocument/2006/relationships/image" Target="../media/image17.png"/><Relationship Id="rId14" Type="http://schemas.openxmlformats.org/officeDocument/2006/relationships/oleObject" Target="../embeddings/oleObject11.bin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6.xml"/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8485087"/>
              </p:ext>
            </p:extLst>
          </p:nvPr>
        </p:nvGraphicFramePr>
        <p:xfrm>
          <a:off x="1676400" y="1828800"/>
          <a:ext cx="5549899" cy="15621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92760"/>
                <a:gridCol w="609251"/>
                <a:gridCol w="218950"/>
                <a:gridCol w="723486"/>
                <a:gridCol w="685408"/>
                <a:gridCol w="609251"/>
                <a:gridCol w="710793"/>
              </a:tblGrid>
              <a:tr h="3905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Reg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Region Lengt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>
                          <a:effectLst/>
                        </a:rPr>
                        <a:t>Cytoband Loca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Ev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Gen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miRN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3905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>
                          <a:effectLst/>
                        </a:rPr>
                        <a:t>chr11:105,728,609-109,212,76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100" u="none" strike="noStrike">
                          <a:effectLst/>
                        </a:rPr>
                        <a:t>34841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qE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CN Ga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3905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>
                          <a:effectLst/>
                        </a:rPr>
                        <a:t>chr11:109,618,739-110,068,7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100" u="none" strike="noStrike">
                          <a:effectLst/>
                        </a:rPr>
                        <a:t>4500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qE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CN Ga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3905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>
                          <a:effectLst/>
                        </a:rPr>
                        <a:t>chr11:112,480,026-121,798,6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100" u="none" strike="noStrike" dirty="0">
                          <a:effectLst/>
                        </a:rPr>
                        <a:t>93186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qE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CN Ga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2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066800" y="3886200"/>
            <a:ext cx="173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l Fig. S1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8544786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5095929"/>
              </p:ext>
            </p:extLst>
          </p:nvPr>
        </p:nvGraphicFramePr>
        <p:xfrm>
          <a:off x="4911726" y="4557713"/>
          <a:ext cx="1452563" cy="1431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Chart" r:id="rId4" imgW="4629059" imgH="2552842" progId="Excel.Chart.8">
                  <p:embed/>
                </p:oleObj>
              </mc:Choice>
              <mc:Fallback>
                <p:oleObj name="Chart" r:id="rId4" imgW="4629059" imgH="2552842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2126" t="8582" r="62379" b="17014"/>
                      <a:stretch>
                        <a:fillRect/>
                      </a:stretch>
                    </p:blipFill>
                    <p:spPr bwMode="auto">
                      <a:xfrm>
                        <a:off x="4911726" y="4557713"/>
                        <a:ext cx="1452563" cy="14319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867345"/>
              </p:ext>
            </p:extLst>
          </p:nvPr>
        </p:nvGraphicFramePr>
        <p:xfrm>
          <a:off x="3624263" y="4598988"/>
          <a:ext cx="1481138" cy="1390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name="Chart" r:id="rId6" imgW="4629059" imgH="2552842" progId="Excel.Chart.8">
                  <p:embed/>
                </p:oleObj>
              </mc:Choice>
              <mc:Fallback>
                <p:oleObj name="Chart" r:id="rId6" imgW="4629059" imgH="2552842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440" t="10759" r="62346" b="16980"/>
                      <a:stretch>
                        <a:fillRect/>
                      </a:stretch>
                    </p:blipFill>
                    <p:spPr bwMode="auto">
                      <a:xfrm>
                        <a:off x="3624263" y="4598988"/>
                        <a:ext cx="1481138" cy="13906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oup 5"/>
          <p:cNvGrpSpPr/>
          <p:nvPr/>
        </p:nvGrpSpPr>
        <p:grpSpPr>
          <a:xfrm>
            <a:off x="2385060" y="4552950"/>
            <a:ext cx="1465421" cy="1419225"/>
            <a:chOff x="7373779" y="4600575"/>
            <a:chExt cx="1465421" cy="1419225"/>
          </a:xfrm>
        </p:grpSpPr>
        <p:pic>
          <p:nvPicPr>
            <p:cNvPr id="1040" name="Picture 16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74"/>
            <a:stretch/>
          </p:blipFill>
          <p:spPr bwMode="auto">
            <a:xfrm>
              <a:off x="7600950" y="4600575"/>
              <a:ext cx="1238250" cy="14192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7086360" y="5257560"/>
              <a:ext cx="8210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Fold change</a:t>
              </a:r>
              <a:endParaRPr lang="en-US" sz="1000" b="1" dirty="0"/>
            </a:p>
          </p:txBody>
        </p:sp>
      </p:grpSp>
      <p:sp>
        <p:nvSpPr>
          <p:cNvPr id="12" name="AutoShape 10"/>
          <p:cNvSpPr>
            <a:spLocks noChangeArrowheads="1"/>
          </p:cNvSpPr>
          <p:nvPr/>
        </p:nvSpPr>
        <p:spPr bwMode="auto">
          <a:xfrm>
            <a:off x="5527255" y="3229015"/>
            <a:ext cx="258762" cy="88900"/>
          </a:xfrm>
          <a:prstGeom prst="leftArrow">
            <a:avLst>
              <a:gd name="adj1" fmla="val 50000"/>
              <a:gd name="adj2" fmla="val 72768"/>
            </a:avLst>
          </a:prstGeom>
          <a:solidFill>
            <a:srgbClr val="FF00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15" name="Text Box 19"/>
          <p:cNvSpPr txBox="1">
            <a:spLocks noChangeArrowheads="1"/>
          </p:cNvSpPr>
          <p:nvPr/>
        </p:nvSpPr>
        <p:spPr bwMode="auto">
          <a:xfrm>
            <a:off x="5535613" y="4540250"/>
            <a:ext cx="725488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b="1" dirty="0"/>
              <a:t>Ube2o</a:t>
            </a:r>
          </a:p>
        </p:txBody>
      </p:sp>
      <p:sp>
        <p:nvSpPr>
          <p:cNvPr id="17" name="Text Box 21"/>
          <p:cNvSpPr txBox="1">
            <a:spLocks noChangeArrowheads="1"/>
          </p:cNvSpPr>
          <p:nvPr/>
        </p:nvSpPr>
        <p:spPr bwMode="auto">
          <a:xfrm>
            <a:off x="4232276" y="4530725"/>
            <a:ext cx="76517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b="1"/>
              <a:t>Tnrc6c</a:t>
            </a:r>
          </a:p>
        </p:txBody>
      </p:sp>
      <p:sp>
        <p:nvSpPr>
          <p:cNvPr id="19" name="Text Box 23"/>
          <p:cNvSpPr txBox="1">
            <a:spLocks noChangeArrowheads="1"/>
          </p:cNvSpPr>
          <p:nvPr/>
        </p:nvSpPr>
        <p:spPr bwMode="auto">
          <a:xfrm>
            <a:off x="3006726" y="4540250"/>
            <a:ext cx="755650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b="1" dirty="0"/>
              <a:t>JMJD6</a:t>
            </a:r>
          </a:p>
        </p:txBody>
      </p:sp>
      <p:sp>
        <p:nvSpPr>
          <p:cNvPr id="24" name="Text Box 28"/>
          <p:cNvSpPr txBox="1">
            <a:spLocks noChangeArrowheads="1"/>
          </p:cNvSpPr>
          <p:nvPr/>
        </p:nvSpPr>
        <p:spPr bwMode="auto">
          <a:xfrm>
            <a:off x="5292726" y="5859462"/>
            <a:ext cx="57977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dirty="0" smtClean="0"/>
              <a:t>88CT1</a:t>
            </a:r>
            <a:endParaRPr lang="en-US" altLang="en-US" sz="1200" b="1" dirty="0"/>
          </a:p>
        </p:txBody>
      </p:sp>
      <p:sp>
        <p:nvSpPr>
          <p:cNvPr id="25" name="Text Box 29"/>
          <p:cNvSpPr txBox="1">
            <a:spLocks noChangeArrowheads="1"/>
          </p:cNvSpPr>
          <p:nvPr/>
        </p:nvSpPr>
        <p:spPr bwMode="auto">
          <a:xfrm>
            <a:off x="5807076" y="5859462"/>
            <a:ext cx="61074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dirty="0"/>
              <a:t>Myc83</a:t>
            </a:r>
          </a:p>
        </p:txBody>
      </p:sp>
      <p:sp>
        <p:nvSpPr>
          <p:cNvPr id="26" name="Text Box 30"/>
          <p:cNvSpPr txBox="1">
            <a:spLocks noChangeArrowheads="1"/>
          </p:cNvSpPr>
          <p:nvPr/>
        </p:nvSpPr>
        <p:spPr bwMode="auto">
          <a:xfrm>
            <a:off x="4168776" y="4191000"/>
            <a:ext cx="814518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b="1" dirty="0" smtClean="0"/>
              <a:t>RT-</a:t>
            </a:r>
            <a:r>
              <a:rPr lang="en-US" altLang="en-US" sz="1400" b="1" dirty="0" err="1" smtClean="0"/>
              <a:t>qPCR</a:t>
            </a:r>
            <a:endParaRPr lang="en-US" altLang="en-US" sz="1400" b="1" dirty="0"/>
          </a:p>
        </p:txBody>
      </p:sp>
      <p:sp>
        <p:nvSpPr>
          <p:cNvPr id="27" name="Text Box 28"/>
          <p:cNvSpPr txBox="1">
            <a:spLocks noChangeArrowheads="1"/>
          </p:cNvSpPr>
          <p:nvPr/>
        </p:nvSpPr>
        <p:spPr bwMode="auto">
          <a:xfrm>
            <a:off x="4076700" y="5859462"/>
            <a:ext cx="57977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dirty="0" smtClean="0"/>
              <a:t>88CT1</a:t>
            </a:r>
            <a:endParaRPr lang="en-US" altLang="en-US" sz="1200" b="1" dirty="0"/>
          </a:p>
        </p:txBody>
      </p:sp>
      <p:sp>
        <p:nvSpPr>
          <p:cNvPr id="28" name="Text Box 29"/>
          <p:cNvSpPr txBox="1">
            <a:spLocks noChangeArrowheads="1"/>
          </p:cNvSpPr>
          <p:nvPr/>
        </p:nvSpPr>
        <p:spPr bwMode="auto">
          <a:xfrm>
            <a:off x="4591050" y="5859462"/>
            <a:ext cx="61074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dirty="0"/>
              <a:t>Myc83</a:t>
            </a:r>
          </a:p>
        </p:txBody>
      </p:sp>
      <p:sp>
        <p:nvSpPr>
          <p:cNvPr id="29" name="Text Box 28"/>
          <p:cNvSpPr txBox="1">
            <a:spLocks noChangeArrowheads="1"/>
          </p:cNvSpPr>
          <p:nvPr/>
        </p:nvSpPr>
        <p:spPr bwMode="auto">
          <a:xfrm>
            <a:off x="2809875" y="5859462"/>
            <a:ext cx="57977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dirty="0" smtClean="0"/>
              <a:t>88CT1</a:t>
            </a:r>
            <a:endParaRPr lang="en-US" altLang="en-US" sz="1200" b="1" dirty="0"/>
          </a:p>
        </p:txBody>
      </p:sp>
      <p:sp>
        <p:nvSpPr>
          <p:cNvPr id="30" name="Text Box 29"/>
          <p:cNvSpPr txBox="1">
            <a:spLocks noChangeArrowheads="1"/>
          </p:cNvSpPr>
          <p:nvPr/>
        </p:nvSpPr>
        <p:spPr bwMode="auto">
          <a:xfrm>
            <a:off x="3324225" y="5859462"/>
            <a:ext cx="61074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dirty="0"/>
              <a:t>Myc83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14400" y="6138805"/>
            <a:ext cx="173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l Fig. S2</a:t>
            </a:r>
            <a:endParaRPr lang="en-US" sz="14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892084" y="11430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204900" y="433546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1" name="Text Box 6"/>
          <p:cNvSpPr txBox="1">
            <a:spLocks noChangeArrowheads="1"/>
          </p:cNvSpPr>
          <p:nvPr/>
        </p:nvSpPr>
        <p:spPr bwMode="auto">
          <a:xfrm>
            <a:off x="5440421" y="1447800"/>
            <a:ext cx="57419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/>
              <a:t>Myc83</a:t>
            </a:r>
          </a:p>
        </p:txBody>
      </p:sp>
      <p:sp>
        <p:nvSpPr>
          <p:cNvPr id="33" name="Text Box 9"/>
          <p:cNvSpPr txBox="1">
            <a:spLocks noChangeArrowheads="1"/>
          </p:cNvSpPr>
          <p:nvPr/>
        </p:nvSpPr>
        <p:spPr bwMode="auto">
          <a:xfrm>
            <a:off x="2903929" y="1480314"/>
            <a:ext cx="56778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 smtClean="0"/>
              <a:t>88CT1</a:t>
            </a:r>
            <a:endParaRPr lang="en-US" altLang="en-US" sz="1000" b="1" dirty="0"/>
          </a:p>
        </p:txBody>
      </p:sp>
      <p:grpSp>
        <p:nvGrpSpPr>
          <p:cNvPr id="37" name="Group 36"/>
          <p:cNvGrpSpPr/>
          <p:nvPr/>
        </p:nvGrpSpPr>
        <p:grpSpPr>
          <a:xfrm>
            <a:off x="1905000" y="1514574"/>
            <a:ext cx="2508979" cy="2318632"/>
            <a:chOff x="4755927" y="458788"/>
            <a:chExt cx="3343048" cy="3173412"/>
          </a:xfrm>
        </p:grpSpPr>
        <p:pic>
          <p:nvPicPr>
            <p:cNvPr id="38" name="Picture 5" descr="cMyc_CGH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76800" y="704850"/>
              <a:ext cx="3221038" cy="29273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Rectangle 14"/>
            <p:cNvSpPr>
              <a:spLocks noChangeArrowheads="1"/>
            </p:cNvSpPr>
            <p:nvPr/>
          </p:nvSpPr>
          <p:spPr bwMode="auto">
            <a:xfrm>
              <a:off x="4755927" y="458788"/>
              <a:ext cx="3343048" cy="311467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4521086" y="1497935"/>
            <a:ext cx="2436133" cy="2279196"/>
            <a:chOff x="2908753" y="3609975"/>
            <a:chExt cx="3245985" cy="3119438"/>
          </a:xfrm>
        </p:grpSpPr>
        <p:pic>
          <p:nvPicPr>
            <p:cNvPr id="41" name="Picture 8" descr="myc83_CGH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13075" y="3819525"/>
              <a:ext cx="3141663" cy="290988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2" name="Rectangle 16"/>
            <p:cNvSpPr>
              <a:spLocks noChangeArrowheads="1"/>
            </p:cNvSpPr>
            <p:nvPr/>
          </p:nvSpPr>
          <p:spPr bwMode="auto">
            <a:xfrm>
              <a:off x="2908753" y="3609975"/>
              <a:ext cx="3245985" cy="311467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sp>
        <p:nvSpPr>
          <p:cNvPr id="43" name="Right Arrow 42"/>
          <p:cNvSpPr/>
          <p:nvPr/>
        </p:nvSpPr>
        <p:spPr>
          <a:xfrm flipH="1">
            <a:off x="7005217" y="2324100"/>
            <a:ext cx="228600" cy="45719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45873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872433"/>
              </p:ext>
            </p:extLst>
          </p:nvPr>
        </p:nvGraphicFramePr>
        <p:xfrm>
          <a:off x="414376" y="3178628"/>
          <a:ext cx="1759611" cy="12792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6854334"/>
              </p:ext>
            </p:extLst>
          </p:nvPr>
        </p:nvGraphicFramePr>
        <p:xfrm>
          <a:off x="445437" y="1763101"/>
          <a:ext cx="1691217" cy="1285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2226434"/>
              </p:ext>
            </p:extLst>
          </p:nvPr>
        </p:nvGraphicFramePr>
        <p:xfrm>
          <a:off x="403490" y="4782359"/>
          <a:ext cx="1828800" cy="12924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8695032"/>
              </p:ext>
            </p:extLst>
          </p:nvPr>
        </p:nvGraphicFramePr>
        <p:xfrm>
          <a:off x="2232290" y="1654628"/>
          <a:ext cx="1653910" cy="14236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6004451"/>
              </p:ext>
            </p:extLst>
          </p:nvPr>
        </p:nvGraphicFramePr>
        <p:xfrm>
          <a:off x="2079890" y="3178628"/>
          <a:ext cx="1765829" cy="1325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7104206"/>
              </p:ext>
            </p:extLst>
          </p:nvPr>
        </p:nvGraphicFramePr>
        <p:xfrm>
          <a:off x="2114755" y="4789585"/>
          <a:ext cx="1790700" cy="13422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546490" y="759023"/>
            <a:ext cx="14366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yc83 cell lin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4870276"/>
              </p:ext>
            </p:extLst>
          </p:nvPr>
        </p:nvGraphicFramePr>
        <p:xfrm>
          <a:off x="4169229" y="1279003"/>
          <a:ext cx="2612571" cy="18595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5663000"/>
              </p:ext>
            </p:extLst>
          </p:nvPr>
        </p:nvGraphicFramePr>
        <p:xfrm>
          <a:off x="4060500" y="3058501"/>
          <a:ext cx="2786743" cy="14292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4156800"/>
              </p:ext>
            </p:extLst>
          </p:nvPr>
        </p:nvGraphicFramePr>
        <p:xfrm>
          <a:off x="4060387" y="4706159"/>
          <a:ext cx="2797613" cy="1392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4575555"/>
              </p:ext>
            </p:extLst>
          </p:nvPr>
        </p:nvGraphicFramePr>
        <p:xfrm>
          <a:off x="6477000" y="1680022"/>
          <a:ext cx="2057400" cy="13983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0043929"/>
              </p:ext>
            </p:extLst>
          </p:nvPr>
        </p:nvGraphicFramePr>
        <p:xfrm>
          <a:off x="6172200" y="2993955"/>
          <a:ext cx="2590800" cy="15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7117616"/>
              </p:ext>
            </p:extLst>
          </p:nvPr>
        </p:nvGraphicFramePr>
        <p:xfrm>
          <a:off x="6096000" y="4586417"/>
          <a:ext cx="3124200" cy="15857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1115121" y="1556912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FBF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743921" y="1556912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Ube2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017560" y="1556912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FBF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196601" y="1556018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Ube2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115121" y="3161007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Birc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017560" y="3161007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Birc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743921" y="3157112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TK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196601" y="3157112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TK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15121" y="4702628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Sumo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017560" y="4702628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Sumo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743921" y="4702628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Tnrc6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196601" y="4702628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Tnrc6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410200" y="758121"/>
            <a:ext cx="156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uMG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 lin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oup 33"/>
          <p:cNvGrpSpPr/>
          <p:nvPr/>
        </p:nvGrpSpPr>
        <p:grpSpPr>
          <a:xfrm>
            <a:off x="7196601" y="775759"/>
            <a:ext cx="804399" cy="441653"/>
            <a:chOff x="7196601" y="545052"/>
            <a:chExt cx="804399" cy="441653"/>
          </a:xfrm>
        </p:grpSpPr>
        <p:sp>
          <p:nvSpPr>
            <p:cNvPr id="30" name="Rectangle 29"/>
            <p:cNvSpPr/>
            <p:nvPr/>
          </p:nvSpPr>
          <p:spPr>
            <a:xfrm>
              <a:off x="7196601" y="609600"/>
              <a:ext cx="118599" cy="104001"/>
            </a:xfrm>
            <a:prstGeom prst="rect">
              <a:avLst/>
            </a:prstGeom>
            <a:solidFill>
              <a:srgbClr val="6699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7206726" y="810399"/>
              <a:ext cx="118599" cy="104001"/>
            </a:xfrm>
            <a:prstGeom prst="rect">
              <a:avLst/>
            </a:prstGeom>
            <a:solidFill>
              <a:srgbClr val="993366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288946" y="545052"/>
              <a:ext cx="7120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FF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282926" y="740484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Text Box 69"/>
          <p:cNvSpPr txBox="1">
            <a:spLocks noChangeArrowheads="1"/>
          </p:cNvSpPr>
          <p:nvPr/>
        </p:nvSpPr>
        <p:spPr bwMode="auto">
          <a:xfrm rot="16200000">
            <a:off x="-85724" y="3590925"/>
            <a:ext cx="10255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% dead/control</a:t>
            </a:r>
          </a:p>
        </p:txBody>
      </p:sp>
      <p:sp>
        <p:nvSpPr>
          <p:cNvPr id="36" name="Text Box 44"/>
          <p:cNvSpPr txBox="1">
            <a:spLocks noChangeArrowheads="1"/>
          </p:cNvSpPr>
          <p:nvPr/>
        </p:nvSpPr>
        <p:spPr bwMode="auto">
          <a:xfrm rot="16200000">
            <a:off x="-77786" y="2177914"/>
            <a:ext cx="10255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% dead/control</a:t>
            </a:r>
          </a:p>
        </p:txBody>
      </p:sp>
      <p:sp>
        <p:nvSpPr>
          <p:cNvPr id="37" name="Text Box 69"/>
          <p:cNvSpPr txBox="1">
            <a:spLocks noChangeArrowheads="1"/>
          </p:cNvSpPr>
          <p:nvPr/>
        </p:nvSpPr>
        <p:spPr bwMode="auto">
          <a:xfrm rot="16200000">
            <a:off x="-85724" y="5191125"/>
            <a:ext cx="10255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% dead/control</a:t>
            </a:r>
          </a:p>
        </p:txBody>
      </p:sp>
      <p:sp>
        <p:nvSpPr>
          <p:cNvPr id="38" name="Text Box 69"/>
          <p:cNvSpPr txBox="1">
            <a:spLocks noChangeArrowheads="1"/>
          </p:cNvSpPr>
          <p:nvPr/>
        </p:nvSpPr>
        <p:spPr bwMode="auto">
          <a:xfrm rot="16200000">
            <a:off x="3648075" y="3594236"/>
            <a:ext cx="10255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% dead/control</a:t>
            </a:r>
          </a:p>
        </p:txBody>
      </p:sp>
      <p:sp>
        <p:nvSpPr>
          <p:cNvPr id="39" name="Text Box 44"/>
          <p:cNvSpPr txBox="1">
            <a:spLocks noChangeArrowheads="1"/>
          </p:cNvSpPr>
          <p:nvPr/>
        </p:nvSpPr>
        <p:spPr bwMode="auto">
          <a:xfrm rot="16200000">
            <a:off x="3656013" y="2181225"/>
            <a:ext cx="10255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% dead/control</a:t>
            </a:r>
          </a:p>
        </p:txBody>
      </p:sp>
      <p:sp>
        <p:nvSpPr>
          <p:cNvPr id="40" name="Text Box 69"/>
          <p:cNvSpPr txBox="1">
            <a:spLocks noChangeArrowheads="1"/>
          </p:cNvSpPr>
          <p:nvPr/>
        </p:nvSpPr>
        <p:spPr bwMode="auto">
          <a:xfrm rot="16200000">
            <a:off x="3648075" y="5194436"/>
            <a:ext cx="10255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/>
              <a:t>% dead/control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81000" y="6077614"/>
            <a:ext cx="173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l Fig. S3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649146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2665" y="3132138"/>
            <a:ext cx="1066800" cy="381000"/>
          </a:xfrm>
          <a:prstGeom prst="rect">
            <a:avLst/>
          </a:prstGeom>
          <a:noFill/>
          <a:ln w="1905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" name="Text Box 11"/>
          <p:cNvSpPr txBox="1">
            <a:spLocks noChangeArrowheads="1"/>
          </p:cNvSpPr>
          <p:nvPr/>
        </p:nvSpPr>
        <p:spPr bwMode="auto">
          <a:xfrm>
            <a:off x="3951864" y="3200400"/>
            <a:ext cx="67310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dirty="0">
                <a:cs typeface="Arial" charset="0"/>
              </a:rPr>
              <a:t>JMJD6</a:t>
            </a:r>
          </a:p>
        </p:txBody>
      </p:sp>
      <p:sp>
        <p:nvSpPr>
          <p:cNvPr id="5" name="Text Box 12"/>
          <p:cNvSpPr txBox="1">
            <a:spLocks noChangeArrowheads="1"/>
          </p:cNvSpPr>
          <p:nvPr/>
        </p:nvSpPr>
        <p:spPr bwMode="auto">
          <a:xfrm>
            <a:off x="2839027" y="1981200"/>
            <a:ext cx="85407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b="1" dirty="0" err="1">
                <a:cs typeface="Arial" charset="0"/>
              </a:rPr>
              <a:t>NMuMG</a:t>
            </a:r>
            <a:endParaRPr lang="en-US" altLang="en-US" sz="1400" b="1" dirty="0">
              <a:cs typeface="Arial" charset="0"/>
            </a:endParaRPr>
          </a:p>
        </p:txBody>
      </p:sp>
      <p:graphicFrame>
        <p:nvGraphicFramePr>
          <p:cNvPr id="6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3415572"/>
              </p:ext>
            </p:extLst>
          </p:nvPr>
        </p:nvGraphicFramePr>
        <p:xfrm>
          <a:off x="4713864" y="3590925"/>
          <a:ext cx="1153536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2" name="Image" r:id="rId4" imgW="889905" imgH="318234" progId="Photoshop.Image.11">
                  <p:embed/>
                </p:oleObj>
              </mc:Choice>
              <mc:Fallback>
                <p:oleObj name="Image" r:id="rId4" imgW="889905" imgH="318234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13864" y="3590925"/>
                        <a:ext cx="1153536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5960749"/>
              </p:ext>
            </p:extLst>
          </p:nvPr>
        </p:nvGraphicFramePr>
        <p:xfrm>
          <a:off x="2732665" y="3622675"/>
          <a:ext cx="1066800" cy="33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3" name="Image" r:id="rId6" imgW="840965" imgH="330485" progId="Photoshop.Image.11">
                  <p:embed/>
                </p:oleObj>
              </mc:Choice>
              <mc:Fallback>
                <p:oleObj name="Image" r:id="rId6" imgW="840965" imgH="330485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32665" y="3622675"/>
                        <a:ext cx="1066800" cy="330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 Box 28"/>
          <p:cNvSpPr txBox="1">
            <a:spLocks noChangeArrowheads="1"/>
          </p:cNvSpPr>
          <p:nvPr/>
        </p:nvSpPr>
        <p:spPr bwMode="auto">
          <a:xfrm>
            <a:off x="3967739" y="3611563"/>
            <a:ext cx="674688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Symbol" pitchFamily="18" charset="2"/>
                <a:cs typeface="Arial" charset="0"/>
              </a:rPr>
              <a:t>b</a:t>
            </a:r>
            <a:r>
              <a:rPr lang="en-US" altLang="en-US" sz="1200" b="1" dirty="0">
                <a:cs typeface="Arial" charset="0"/>
              </a:rPr>
              <a:t>-actin</a:t>
            </a:r>
          </a:p>
        </p:txBody>
      </p:sp>
      <p:sp>
        <p:nvSpPr>
          <p:cNvPr id="9" name="Text Box 32"/>
          <p:cNvSpPr txBox="1">
            <a:spLocks noChangeArrowheads="1"/>
          </p:cNvSpPr>
          <p:nvPr/>
        </p:nvSpPr>
        <p:spPr bwMode="auto">
          <a:xfrm rot="16200000">
            <a:off x="2445592" y="2600510"/>
            <a:ext cx="972767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dirty="0" smtClean="0">
                <a:cs typeface="Arial" charset="0"/>
              </a:rPr>
              <a:t>Empty</a:t>
            </a:r>
            <a:r>
              <a:rPr lang="en-US" altLang="en-US" sz="1000" b="1" dirty="0" smtClean="0">
                <a:cs typeface="Arial" charset="0"/>
              </a:rPr>
              <a:t> Vector</a:t>
            </a:r>
            <a:endParaRPr lang="en-US" altLang="en-US" sz="1000" b="1" dirty="0">
              <a:cs typeface="Arial" charset="0"/>
            </a:endParaRPr>
          </a:p>
        </p:txBody>
      </p:sp>
      <p:sp>
        <p:nvSpPr>
          <p:cNvPr id="10" name="Text Box 33"/>
          <p:cNvSpPr txBox="1">
            <a:spLocks noChangeArrowheads="1"/>
          </p:cNvSpPr>
          <p:nvPr/>
        </p:nvSpPr>
        <p:spPr bwMode="auto">
          <a:xfrm rot="16200000">
            <a:off x="2846192" y="2619746"/>
            <a:ext cx="86754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dirty="0" smtClean="0">
                <a:cs typeface="Arial" charset="0"/>
              </a:rPr>
              <a:t>shJMJD6-1</a:t>
            </a:r>
            <a:endParaRPr lang="en-US" altLang="en-US" sz="1200" dirty="0">
              <a:cs typeface="Arial" charset="0"/>
            </a:endParaRPr>
          </a:p>
        </p:txBody>
      </p:sp>
      <p:sp>
        <p:nvSpPr>
          <p:cNvPr id="11" name="Text Box 34"/>
          <p:cNvSpPr txBox="1">
            <a:spLocks noChangeArrowheads="1"/>
          </p:cNvSpPr>
          <p:nvPr/>
        </p:nvSpPr>
        <p:spPr bwMode="auto">
          <a:xfrm rot="16200000">
            <a:off x="3199391" y="2619746"/>
            <a:ext cx="86754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dirty="0" smtClean="0">
                <a:cs typeface="Arial" charset="0"/>
              </a:rPr>
              <a:t>shJMJD6-2</a:t>
            </a:r>
            <a:endParaRPr lang="en-US" altLang="en-US" sz="1200" dirty="0">
              <a:cs typeface="Arial" charset="0"/>
            </a:endParaRPr>
          </a:p>
        </p:txBody>
      </p:sp>
      <p:pic>
        <p:nvPicPr>
          <p:cNvPr id="12" name="Picture 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8" r="23823"/>
          <a:stretch/>
        </p:blipFill>
        <p:spPr bwMode="auto">
          <a:xfrm>
            <a:off x="4713864" y="3132138"/>
            <a:ext cx="1153536" cy="38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 Box 32"/>
          <p:cNvSpPr txBox="1">
            <a:spLocks noChangeArrowheads="1"/>
          </p:cNvSpPr>
          <p:nvPr/>
        </p:nvSpPr>
        <p:spPr bwMode="auto">
          <a:xfrm rot="16200000">
            <a:off x="4459466" y="2600509"/>
            <a:ext cx="96302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dirty="0" smtClean="0">
                <a:cs typeface="Arial" charset="0"/>
              </a:rPr>
              <a:t>Empty</a:t>
            </a:r>
            <a:r>
              <a:rPr lang="en-US" altLang="en-US" sz="1000" b="1" dirty="0" smtClean="0">
                <a:cs typeface="Arial" charset="0"/>
              </a:rPr>
              <a:t> Vector</a:t>
            </a:r>
            <a:endParaRPr lang="en-US" altLang="en-US" sz="1000" b="1" dirty="0">
              <a:cs typeface="Arial" charset="0"/>
            </a:endParaRPr>
          </a:p>
        </p:txBody>
      </p:sp>
      <p:sp>
        <p:nvSpPr>
          <p:cNvPr id="14" name="Text Box 33"/>
          <p:cNvSpPr txBox="1">
            <a:spLocks noChangeArrowheads="1"/>
          </p:cNvSpPr>
          <p:nvPr/>
        </p:nvSpPr>
        <p:spPr bwMode="auto">
          <a:xfrm rot="16200000">
            <a:off x="4855193" y="2619745"/>
            <a:ext cx="86754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dirty="0" smtClean="0">
                <a:cs typeface="Arial" charset="0"/>
              </a:rPr>
              <a:t>shJMJD6-1</a:t>
            </a:r>
            <a:endParaRPr lang="en-US" altLang="en-US" sz="1200" dirty="0">
              <a:cs typeface="Arial" charset="0"/>
            </a:endParaRPr>
          </a:p>
        </p:txBody>
      </p:sp>
      <p:sp>
        <p:nvSpPr>
          <p:cNvPr id="15" name="Text Box 34"/>
          <p:cNvSpPr txBox="1">
            <a:spLocks noChangeArrowheads="1"/>
          </p:cNvSpPr>
          <p:nvPr/>
        </p:nvSpPr>
        <p:spPr bwMode="auto">
          <a:xfrm rot="16200000">
            <a:off x="5208392" y="2619745"/>
            <a:ext cx="86754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 dirty="0" smtClean="0">
                <a:cs typeface="Arial" charset="0"/>
              </a:rPr>
              <a:t>shJMJD6-2</a:t>
            </a:r>
            <a:endParaRPr lang="en-US" altLang="en-US" sz="1200" dirty="0">
              <a:cs typeface="Arial" charset="0"/>
            </a:endParaRPr>
          </a:p>
        </p:txBody>
      </p:sp>
      <p:sp>
        <p:nvSpPr>
          <p:cNvPr id="16" name="Text Box 12"/>
          <p:cNvSpPr txBox="1">
            <a:spLocks noChangeArrowheads="1"/>
          </p:cNvSpPr>
          <p:nvPr/>
        </p:nvSpPr>
        <p:spPr bwMode="auto">
          <a:xfrm>
            <a:off x="4866264" y="1981200"/>
            <a:ext cx="68249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400" b="1" dirty="0" smtClean="0">
                <a:cs typeface="Arial" charset="0"/>
              </a:rPr>
              <a:t>Myc83</a:t>
            </a:r>
            <a:endParaRPr lang="en-US" altLang="en-US" sz="1400" b="1" dirty="0">
              <a:cs typeface="Arial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914400" y="6138805"/>
            <a:ext cx="173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l Fig. S4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3641204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"/>
          <p:cNvSpPr txBox="1">
            <a:spLocks noChangeArrowheads="1"/>
          </p:cNvSpPr>
          <p:nvPr/>
        </p:nvSpPr>
        <p:spPr bwMode="auto">
          <a:xfrm>
            <a:off x="3557587" y="762000"/>
            <a:ext cx="73609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err="1">
                <a:latin typeface="+mj-lt"/>
                <a:cs typeface="Arial" charset="0"/>
              </a:rPr>
              <a:t>NMuMG</a:t>
            </a:r>
            <a:endParaRPr lang="en-US" altLang="en-US" sz="1200" b="1" dirty="0">
              <a:latin typeface="+mj-lt"/>
              <a:cs typeface="Arial" charset="0"/>
            </a:endParaRPr>
          </a:p>
        </p:txBody>
      </p:sp>
      <p:sp>
        <p:nvSpPr>
          <p:cNvPr id="3" name="Text Box 5"/>
          <p:cNvSpPr txBox="1">
            <a:spLocks noChangeArrowheads="1"/>
          </p:cNvSpPr>
          <p:nvPr/>
        </p:nvSpPr>
        <p:spPr bwMode="auto">
          <a:xfrm>
            <a:off x="5943600" y="1725454"/>
            <a:ext cx="117436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smtClean="0">
                <a:latin typeface="+mj-lt"/>
                <a:cs typeface="Arial" charset="0"/>
              </a:rPr>
              <a:t>MycER-LacZ-V5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smtClean="0">
                <a:latin typeface="+mj-lt"/>
                <a:cs typeface="Arial" charset="0"/>
              </a:rPr>
              <a:t>expressing cells</a:t>
            </a:r>
            <a:endParaRPr lang="en-US" altLang="en-US" sz="1200" b="1" dirty="0">
              <a:latin typeface="+mj-lt"/>
              <a:cs typeface="Arial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+mj-lt"/>
                <a:cs typeface="Arial" charset="0"/>
              </a:rPr>
              <a:t>     </a:t>
            </a:r>
          </a:p>
        </p:txBody>
      </p:sp>
      <p:sp>
        <p:nvSpPr>
          <p:cNvPr id="4" name="Text Box 6"/>
          <p:cNvSpPr txBox="1">
            <a:spLocks noChangeArrowheads="1"/>
          </p:cNvSpPr>
          <p:nvPr/>
        </p:nvSpPr>
        <p:spPr bwMode="auto">
          <a:xfrm>
            <a:off x="5959475" y="3490099"/>
            <a:ext cx="129202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smtClean="0">
                <a:latin typeface="+mj-lt"/>
                <a:cs typeface="Arial" charset="0"/>
              </a:rPr>
              <a:t>MycER-JMJD6-V5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smtClean="0">
                <a:latin typeface="+mj-lt"/>
                <a:cs typeface="Arial" charset="0"/>
              </a:rPr>
              <a:t>expressing cells</a:t>
            </a:r>
            <a:endParaRPr lang="en-US" altLang="en-US" sz="1200" b="1" dirty="0">
              <a:latin typeface="+mj-lt"/>
              <a:cs typeface="Arial" charset="0"/>
            </a:endParaRPr>
          </a:p>
        </p:txBody>
      </p:sp>
      <p:sp>
        <p:nvSpPr>
          <p:cNvPr id="5" name="Text Box 7"/>
          <p:cNvSpPr txBox="1">
            <a:spLocks noChangeArrowheads="1"/>
          </p:cNvSpPr>
          <p:nvPr/>
        </p:nvSpPr>
        <p:spPr bwMode="auto">
          <a:xfrm>
            <a:off x="2649537" y="4495800"/>
            <a:ext cx="74667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+mj-lt"/>
                <a:cs typeface="Arial" charset="0"/>
              </a:rPr>
              <a:t>Red – V5</a:t>
            </a:r>
          </a:p>
        </p:txBody>
      </p:sp>
      <p:pic>
        <p:nvPicPr>
          <p:cNvPr id="6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7425" y="2771775"/>
            <a:ext cx="1828800" cy="1691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4800" y="2771776"/>
            <a:ext cx="1828800" cy="17014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0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4800" y="1038999"/>
            <a:ext cx="1828800" cy="16956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11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7425" y="1029474"/>
            <a:ext cx="1828800" cy="17106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 Box 24"/>
          <p:cNvSpPr txBox="1">
            <a:spLocks noChangeArrowheads="1"/>
          </p:cNvSpPr>
          <p:nvPr/>
        </p:nvSpPr>
        <p:spPr bwMode="auto">
          <a:xfrm>
            <a:off x="4573587" y="4514850"/>
            <a:ext cx="4952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>
                <a:latin typeface="+mj-lt"/>
                <a:cs typeface="Arial" charset="0"/>
              </a:rPr>
              <a:t>DAPI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55087" y="6353273"/>
            <a:ext cx="16928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l Fig.S5</a:t>
            </a:r>
            <a:endParaRPr lang="en-US" sz="1400" b="1" dirty="0"/>
          </a:p>
        </p:txBody>
      </p:sp>
      <p:graphicFrame>
        <p:nvGraphicFramePr>
          <p:cNvPr id="12" name="Objec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2050652"/>
              </p:ext>
            </p:extLst>
          </p:nvPr>
        </p:nvGraphicFramePr>
        <p:xfrm>
          <a:off x="3454400" y="6241865"/>
          <a:ext cx="1231900" cy="20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Image" r:id="rId8" imgW="1231186" imgH="331924" progId="Photoshop.Image.11">
                  <p:embed/>
                </p:oleObj>
              </mc:Choice>
              <mc:Fallback>
                <p:oleObj name="Image" r:id="rId8" imgW="1231186" imgH="331924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54400" y="6241865"/>
                        <a:ext cx="1231900" cy="203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Line 33"/>
          <p:cNvSpPr>
            <a:spLocks noChangeShapeType="1"/>
          </p:cNvSpPr>
          <p:nvPr/>
        </p:nvSpPr>
        <p:spPr bwMode="auto">
          <a:xfrm>
            <a:off x="4737100" y="6310127"/>
            <a:ext cx="984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>
              <a:latin typeface="+mj-lt"/>
            </a:endParaRPr>
          </a:p>
        </p:txBody>
      </p:sp>
      <p:sp>
        <p:nvSpPr>
          <p:cNvPr id="14" name="Text Box 34"/>
          <p:cNvSpPr txBox="1">
            <a:spLocks noChangeArrowheads="1"/>
          </p:cNvSpPr>
          <p:nvPr/>
        </p:nvSpPr>
        <p:spPr bwMode="auto">
          <a:xfrm>
            <a:off x="4778375" y="6204288"/>
            <a:ext cx="51969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+mj-lt"/>
                <a:cs typeface="Arial" panose="020B0604020202020204" pitchFamily="34" charset="0"/>
              </a:rPr>
              <a:t>51kDa</a:t>
            </a:r>
          </a:p>
        </p:txBody>
      </p:sp>
      <p:sp>
        <p:nvSpPr>
          <p:cNvPr id="15" name="Text Box 35"/>
          <p:cNvSpPr txBox="1">
            <a:spLocks noChangeArrowheads="1"/>
          </p:cNvSpPr>
          <p:nvPr/>
        </p:nvSpPr>
        <p:spPr bwMode="auto">
          <a:xfrm rot="16200000">
            <a:off x="3156989" y="5674685"/>
            <a:ext cx="901209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+mj-lt"/>
                <a:cs typeface="Arial" panose="020B0604020202020204" pitchFamily="34" charset="0"/>
              </a:rPr>
              <a:t>Babe-LacZ-V5</a:t>
            </a:r>
          </a:p>
        </p:txBody>
      </p:sp>
      <p:sp>
        <p:nvSpPr>
          <p:cNvPr id="16" name="Text Box 36"/>
          <p:cNvSpPr txBox="1">
            <a:spLocks noChangeArrowheads="1"/>
          </p:cNvSpPr>
          <p:nvPr/>
        </p:nvSpPr>
        <p:spPr bwMode="auto">
          <a:xfrm rot="16200000">
            <a:off x="3401723" y="5606423"/>
            <a:ext cx="101181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+mj-lt"/>
                <a:cs typeface="Arial" panose="020B0604020202020204" pitchFamily="34" charset="0"/>
              </a:rPr>
              <a:t>Babe-JMJD6-V5</a:t>
            </a:r>
          </a:p>
        </p:txBody>
      </p:sp>
      <p:sp>
        <p:nvSpPr>
          <p:cNvPr id="17" name="Text Box 37"/>
          <p:cNvSpPr txBox="1">
            <a:spLocks noChangeArrowheads="1"/>
          </p:cNvSpPr>
          <p:nvPr/>
        </p:nvSpPr>
        <p:spPr bwMode="auto">
          <a:xfrm rot="16200000">
            <a:off x="3699464" y="5607216"/>
            <a:ext cx="99418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+mj-lt"/>
                <a:cs typeface="Arial" panose="020B0604020202020204" pitchFamily="34" charset="0"/>
              </a:rPr>
              <a:t>MycER-LacZ-V5</a:t>
            </a:r>
          </a:p>
        </p:txBody>
      </p:sp>
      <p:sp>
        <p:nvSpPr>
          <p:cNvPr id="18" name="Text Box 38"/>
          <p:cNvSpPr txBox="1">
            <a:spLocks noChangeArrowheads="1"/>
          </p:cNvSpPr>
          <p:nvPr/>
        </p:nvSpPr>
        <p:spPr bwMode="auto">
          <a:xfrm rot="16200000">
            <a:off x="3942611" y="5540541"/>
            <a:ext cx="110479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+mj-lt"/>
                <a:cs typeface="Arial" panose="020B0604020202020204" pitchFamily="34" charset="0"/>
              </a:rPr>
              <a:t>MycER-JMJD6-V5</a:t>
            </a:r>
          </a:p>
        </p:txBody>
      </p:sp>
      <p:sp>
        <p:nvSpPr>
          <p:cNvPr id="19" name="Text Box 39"/>
          <p:cNvSpPr txBox="1">
            <a:spLocks noChangeArrowheads="1"/>
          </p:cNvSpPr>
          <p:nvPr/>
        </p:nvSpPr>
        <p:spPr bwMode="auto">
          <a:xfrm>
            <a:off x="3611562" y="6507162"/>
            <a:ext cx="772969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+mj-lt"/>
                <a:cs typeface="Arial" panose="020B0604020202020204" pitchFamily="34" charset="0"/>
              </a:rPr>
              <a:t>anti-JMJD6</a:t>
            </a:r>
          </a:p>
        </p:txBody>
      </p:sp>
      <p:sp>
        <p:nvSpPr>
          <p:cNvPr id="20" name="Text Box 42"/>
          <p:cNvSpPr txBox="1">
            <a:spLocks noChangeArrowheads="1"/>
          </p:cNvSpPr>
          <p:nvPr/>
        </p:nvSpPr>
        <p:spPr bwMode="auto">
          <a:xfrm>
            <a:off x="2891902" y="6304393"/>
            <a:ext cx="52610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+mj-lt"/>
                <a:cs typeface="Arial" panose="020B0604020202020204" pitchFamily="34" charset="0"/>
              </a:rPr>
              <a:t>JMJD6</a:t>
            </a:r>
          </a:p>
        </p:txBody>
      </p:sp>
      <p:sp>
        <p:nvSpPr>
          <p:cNvPr id="21" name="Text Box 43"/>
          <p:cNvSpPr txBox="1">
            <a:spLocks noChangeArrowheads="1"/>
          </p:cNvSpPr>
          <p:nvPr/>
        </p:nvSpPr>
        <p:spPr bwMode="auto">
          <a:xfrm>
            <a:off x="2743200" y="6183706"/>
            <a:ext cx="705642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+mj-lt"/>
                <a:cs typeface="Arial" panose="020B0604020202020204" pitchFamily="34" charset="0"/>
              </a:rPr>
              <a:t>JMJD6-V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600200" y="104852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590800" y="5105400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571116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3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0179519"/>
              </p:ext>
            </p:extLst>
          </p:nvPr>
        </p:nvGraphicFramePr>
        <p:xfrm>
          <a:off x="3643313" y="4772025"/>
          <a:ext cx="1563624" cy="15413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2" r:id="rId4" imgW="2666667" imgH="2628571" progId="">
                  <p:embed/>
                </p:oleObj>
              </mc:Choice>
              <mc:Fallback>
                <p:oleObj r:id="rId4" imgW="2666667" imgH="2628571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43313" y="4772025"/>
                        <a:ext cx="1563624" cy="15413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7895076"/>
              </p:ext>
            </p:extLst>
          </p:nvPr>
        </p:nvGraphicFramePr>
        <p:xfrm>
          <a:off x="5253038" y="4772025"/>
          <a:ext cx="1563624" cy="15413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3" r:id="rId6" imgW="2666667" imgH="2628571" progId="">
                  <p:embed/>
                </p:oleObj>
              </mc:Choice>
              <mc:Fallback>
                <p:oleObj r:id="rId6" imgW="2666667" imgH="2628571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53038" y="4772025"/>
                        <a:ext cx="1563624" cy="15413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8443247"/>
              </p:ext>
            </p:extLst>
          </p:nvPr>
        </p:nvGraphicFramePr>
        <p:xfrm>
          <a:off x="2033588" y="4772025"/>
          <a:ext cx="1563624" cy="15413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4" r:id="rId8" imgW="2666667" imgH="2628571" progId="">
                  <p:embed/>
                </p:oleObj>
              </mc:Choice>
              <mc:Fallback>
                <p:oleObj r:id="rId8" imgW="2666667" imgH="2628571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33588" y="4772025"/>
                        <a:ext cx="1563624" cy="15413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 Box 9"/>
          <p:cNvSpPr txBox="1">
            <a:spLocks noChangeArrowheads="1"/>
          </p:cNvSpPr>
          <p:nvPr/>
        </p:nvSpPr>
        <p:spPr bwMode="auto">
          <a:xfrm>
            <a:off x="2424113" y="2966768"/>
            <a:ext cx="45365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err="1">
                <a:latin typeface="+mj-lt"/>
                <a:cs typeface="Arial" charset="0"/>
              </a:rPr>
              <a:t>Myc</a:t>
            </a:r>
            <a:endParaRPr lang="en-US" altLang="en-US" sz="1200" b="1" dirty="0">
              <a:latin typeface="+mj-lt"/>
              <a:cs typeface="Arial" charset="0"/>
            </a:endParaRPr>
          </a:p>
        </p:txBody>
      </p:sp>
      <p:sp>
        <p:nvSpPr>
          <p:cNvPr id="38" name="Text Box 10"/>
          <p:cNvSpPr txBox="1">
            <a:spLocks noChangeArrowheads="1"/>
          </p:cNvSpPr>
          <p:nvPr/>
        </p:nvSpPr>
        <p:spPr bwMode="auto">
          <a:xfrm>
            <a:off x="4252913" y="2966768"/>
            <a:ext cx="4952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>
                <a:latin typeface="+mj-lt"/>
                <a:cs typeface="Arial" charset="0"/>
              </a:rPr>
              <a:t>DAPI</a:t>
            </a:r>
          </a:p>
        </p:txBody>
      </p:sp>
      <p:sp>
        <p:nvSpPr>
          <p:cNvPr id="39" name="Text Box 11"/>
          <p:cNvSpPr txBox="1">
            <a:spLocks noChangeArrowheads="1"/>
          </p:cNvSpPr>
          <p:nvPr/>
        </p:nvSpPr>
        <p:spPr bwMode="auto">
          <a:xfrm>
            <a:off x="5761038" y="2966768"/>
            <a:ext cx="59798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>
                <a:latin typeface="+mj-lt"/>
                <a:cs typeface="Arial" charset="0"/>
              </a:rPr>
              <a:t>Merge</a:t>
            </a:r>
          </a:p>
        </p:txBody>
      </p:sp>
      <p:graphicFrame>
        <p:nvGraphicFramePr>
          <p:cNvPr id="40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8863937"/>
              </p:ext>
            </p:extLst>
          </p:nvPr>
        </p:nvGraphicFramePr>
        <p:xfrm>
          <a:off x="2033588" y="3224213"/>
          <a:ext cx="1566863" cy="151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5" name="Image" r:id="rId10" imgW="3682540" imgH="3555556" progId="Photoshop.Image.11">
                  <p:embed/>
                </p:oleObj>
              </mc:Choice>
              <mc:Fallback>
                <p:oleObj name="Image" r:id="rId10" imgW="3682540" imgH="3555556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33588" y="3224213"/>
                        <a:ext cx="1566863" cy="15113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5190840"/>
              </p:ext>
            </p:extLst>
          </p:nvPr>
        </p:nvGraphicFramePr>
        <p:xfrm>
          <a:off x="3643313" y="3224213"/>
          <a:ext cx="1566863" cy="151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6" name="Image" r:id="rId12" imgW="3682540" imgH="3555556" progId="Photoshop.Image.11">
                  <p:embed/>
                </p:oleObj>
              </mc:Choice>
              <mc:Fallback>
                <p:oleObj name="Image" r:id="rId12" imgW="3682540" imgH="3555556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43313" y="3224213"/>
                        <a:ext cx="1566863" cy="15113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6132788"/>
              </p:ext>
            </p:extLst>
          </p:nvPr>
        </p:nvGraphicFramePr>
        <p:xfrm>
          <a:off x="5253038" y="3224213"/>
          <a:ext cx="1566863" cy="151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7" name="Image" r:id="rId14" imgW="3682540" imgH="3555556" progId="Photoshop.Image.11">
                  <p:embed/>
                </p:oleObj>
              </mc:Choice>
              <mc:Fallback>
                <p:oleObj name="Image" r:id="rId14" imgW="3682540" imgH="3555556" progId="Photoshop.Image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53038" y="3224213"/>
                        <a:ext cx="1566863" cy="15113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Text Box 16"/>
          <p:cNvSpPr txBox="1">
            <a:spLocks noChangeArrowheads="1"/>
          </p:cNvSpPr>
          <p:nvPr/>
        </p:nvSpPr>
        <p:spPr bwMode="auto">
          <a:xfrm>
            <a:off x="6858000" y="3675063"/>
            <a:ext cx="738985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>
                <a:latin typeface="+mj-lt"/>
                <a:cs typeface="Arial" charset="0"/>
              </a:rPr>
              <a:t>EtOH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>
                <a:latin typeface="+mj-lt"/>
                <a:cs typeface="Arial" charset="0"/>
              </a:rPr>
              <a:t>Myc-OFF</a:t>
            </a:r>
          </a:p>
        </p:txBody>
      </p:sp>
      <p:sp>
        <p:nvSpPr>
          <p:cNvPr id="45" name="Text Box 17"/>
          <p:cNvSpPr txBox="1">
            <a:spLocks noChangeArrowheads="1"/>
          </p:cNvSpPr>
          <p:nvPr/>
        </p:nvSpPr>
        <p:spPr bwMode="auto">
          <a:xfrm>
            <a:off x="6858000" y="5222875"/>
            <a:ext cx="70532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+mj-lt"/>
                <a:cs typeface="Arial" charset="0"/>
              </a:rPr>
              <a:t>4-OHT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err="1">
                <a:latin typeface="+mj-lt"/>
                <a:cs typeface="Arial" charset="0"/>
              </a:rPr>
              <a:t>Myc</a:t>
            </a:r>
            <a:r>
              <a:rPr lang="en-US" altLang="en-US" sz="1200" b="1" dirty="0">
                <a:latin typeface="+mj-lt"/>
                <a:cs typeface="Arial" charset="0"/>
              </a:rPr>
              <a:t>-ON</a:t>
            </a:r>
          </a:p>
        </p:txBody>
      </p:sp>
      <p:sp>
        <p:nvSpPr>
          <p:cNvPr id="49" name="Line 21"/>
          <p:cNvSpPr>
            <a:spLocks noChangeShapeType="1"/>
          </p:cNvSpPr>
          <p:nvPr/>
        </p:nvSpPr>
        <p:spPr bwMode="auto">
          <a:xfrm>
            <a:off x="2519362" y="1897063"/>
            <a:ext cx="952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0" name="Text Box 22"/>
          <p:cNvSpPr txBox="1">
            <a:spLocks noChangeArrowheads="1"/>
          </p:cNvSpPr>
          <p:nvPr/>
        </p:nvSpPr>
        <p:spPr bwMode="auto">
          <a:xfrm>
            <a:off x="1989137" y="1774825"/>
            <a:ext cx="6064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 err="1">
                <a:cs typeface="Arial" charset="0"/>
              </a:rPr>
              <a:t>MycER</a:t>
            </a:r>
            <a:endParaRPr lang="en-US" altLang="en-US" sz="1000" dirty="0">
              <a:cs typeface="Arial" charset="0"/>
            </a:endParaRPr>
          </a:p>
        </p:txBody>
      </p:sp>
      <p:sp>
        <p:nvSpPr>
          <p:cNvPr id="53" name="Text Box 25"/>
          <p:cNvSpPr txBox="1">
            <a:spLocks noChangeArrowheads="1"/>
          </p:cNvSpPr>
          <p:nvPr/>
        </p:nvSpPr>
        <p:spPr bwMode="auto">
          <a:xfrm>
            <a:off x="2760662" y="1212850"/>
            <a:ext cx="4794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 err="1">
                <a:cs typeface="Arial" charset="0"/>
              </a:rPr>
              <a:t>LacZ</a:t>
            </a:r>
            <a:endParaRPr lang="en-US" altLang="en-US" sz="1000" dirty="0">
              <a:cs typeface="Arial" charset="0"/>
            </a:endParaRPr>
          </a:p>
        </p:txBody>
      </p:sp>
      <p:sp>
        <p:nvSpPr>
          <p:cNvPr id="54" name="Text Box 26"/>
          <p:cNvSpPr txBox="1">
            <a:spLocks noChangeArrowheads="1"/>
          </p:cNvSpPr>
          <p:nvPr/>
        </p:nvSpPr>
        <p:spPr bwMode="auto">
          <a:xfrm>
            <a:off x="3217862" y="1212850"/>
            <a:ext cx="59213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cs typeface="Arial" charset="0"/>
              </a:rPr>
              <a:t>JMJD6</a:t>
            </a:r>
          </a:p>
        </p:txBody>
      </p:sp>
      <p:sp>
        <p:nvSpPr>
          <p:cNvPr id="56" name="Line 28"/>
          <p:cNvSpPr>
            <a:spLocks noChangeShapeType="1"/>
          </p:cNvSpPr>
          <p:nvPr/>
        </p:nvSpPr>
        <p:spPr bwMode="auto">
          <a:xfrm>
            <a:off x="2738437" y="1439863"/>
            <a:ext cx="4476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7" name="Line 29"/>
          <p:cNvSpPr>
            <a:spLocks noChangeShapeType="1"/>
          </p:cNvSpPr>
          <p:nvPr/>
        </p:nvSpPr>
        <p:spPr bwMode="auto">
          <a:xfrm>
            <a:off x="3271837" y="1439863"/>
            <a:ext cx="4476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58" name="Text Box 30"/>
          <p:cNvSpPr txBox="1">
            <a:spLocks noChangeArrowheads="1"/>
          </p:cNvSpPr>
          <p:nvPr/>
        </p:nvSpPr>
        <p:spPr bwMode="auto">
          <a:xfrm>
            <a:off x="2170112" y="1412875"/>
            <a:ext cx="160337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cs typeface="Arial" charset="0"/>
              </a:rPr>
              <a:t>4-OHT     -       +     -      +</a:t>
            </a:r>
          </a:p>
        </p:txBody>
      </p:sp>
      <p:graphicFrame>
        <p:nvGraphicFramePr>
          <p:cNvPr id="59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6157682"/>
              </p:ext>
            </p:extLst>
          </p:nvPr>
        </p:nvGraphicFramePr>
        <p:xfrm>
          <a:off x="2651125" y="2214563"/>
          <a:ext cx="1117600" cy="338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8" r:id="rId16" imgW="1078903" imgH="338042" progId="">
                  <p:embed/>
                </p:oleObj>
              </mc:Choice>
              <mc:Fallback>
                <p:oleObj r:id="rId16" imgW="1078903" imgH="338042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51125" y="2214563"/>
                        <a:ext cx="1117600" cy="3381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Text Box 32"/>
          <p:cNvSpPr txBox="1">
            <a:spLocks noChangeArrowheads="1"/>
          </p:cNvSpPr>
          <p:nvPr/>
        </p:nvSpPr>
        <p:spPr bwMode="auto">
          <a:xfrm>
            <a:off x="2105025" y="2201863"/>
            <a:ext cx="56778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Symbol" pitchFamily="18" charset="2"/>
                <a:cs typeface="Arial" charset="0"/>
              </a:rPr>
              <a:t>b</a:t>
            </a:r>
            <a:r>
              <a:rPr lang="en-US" altLang="en-US" sz="1000" dirty="0">
                <a:cs typeface="Arial" charset="0"/>
              </a:rPr>
              <a:t>-actin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1650790" y="105896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1611330" y="296882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65" name="Text Box 23"/>
          <p:cNvSpPr txBox="1">
            <a:spLocks noChangeArrowheads="1"/>
          </p:cNvSpPr>
          <p:nvPr/>
        </p:nvSpPr>
        <p:spPr bwMode="auto">
          <a:xfrm>
            <a:off x="4667250" y="1819275"/>
            <a:ext cx="52387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 Box 24"/>
          <p:cNvSpPr txBox="1">
            <a:spLocks noChangeArrowheads="1"/>
          </p:cNvSpPr>
          <p:nvPr/>
        </p:nvSpPr>
        <p:spPr bwMode="auto">
          <a:xfrm rot="16200000">
            <a:off x="5096669" y="1456531"/>
            <a:ext cx="465137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>
                <a:latin typeface="Arial" panose="020B0604020202020204" pitchFamily="34" charset="0"/>
                <a:cs typeface="Arial" panose="020B0604020202020204" pitchFamily="34" charset="0"/>
              </a:rPr>
              <a:t>LacZ</a:t>
            </a:r>
          </a:p>
        </p:txBody>
      </p:sp>
      <p:sp>
        <p:nvSpPr>
          <p:cNvPr id="67" name="Text Box 25"/>
          <p:cNvSpPr txBox="1">
            <a:spLocks noChangeArrowheads="1"/>
          </p:cNvSpPr>
          <p:nvPr/>
        </p:nvSpPr>
        <p:spPr bwMode="auto">
          <a:xfrm rot="16200000">
            <a:off x="5287169" y="1408906"/>
            <a:ext cx="579437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JMJD6</a:t>
            </a:r>
          </a:p>
        </p:txBody>
      </p:sp>
      <p:pic>
        <p:nvPicPr>
          <p:cNvPr id="7397" name="Picture 229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000"/>
          <a:stretch/>
        </p:blipFill>
        <p:spPr bwMode="auto">
          <a:xfrm>
            <a:off x="2647950" y="1647825"/>
            <a:ext cx="1123950" cy="500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6" name="Text Box 32"/>
          <p:cNvSpPr txBox="1">
            <a:spLocks noChangeArrowheads="1"/>
          </p:cNvSpPr>
          <p:nvPr/>
        </p:nvSpPr>
        <p:spPr bwMode="auto">
          <a:xfrm>
            <a:off x="4642391" y="2171700"/>
            <a:ext cx="56778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Symbol" pitchFamily="18" charset="2"/>
                <a:cs typeface="Arial" charset="0"/>
              </a:rPr>
              <a:t>b</a:t>
            </a:r>
            <a:r>
              <a:rPr lang="en-US" altLang="en-US" sz="1000" dirty="0">
                <a:cs typeface="Arial" charset="0"/>
              </a:rPr>
              <a:t>-acti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62171" y="6324600"/>
            <a:ext cx="16928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l Fig.S6</a:t>
            </a:r>
            <a:endParaRPr lang="en-US" sz="1400" b="1" dirty="0"/>
          </a:p>
        </p:txBody>
      </p:sp>
      <p:pic>
        <p:nvPicPr>
          <p:cNvPr id="7588" name="Picture 420"/>
          <p:cNvPicPr>
            <a:picLocks noChangeAspect="1" noChangeArrowheads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 bwMode="auto">
          <a:xfrm>
            <a:off x="5181600" y="1803399"/>
            <a:ext cx="542925" cy="276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590" name="Picture 422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15741"/>
          <a:stretch/>
        </p:blipFill>
        <p:spPr bwMode="auto">
          <a:xfrm>
            <a:off x="5191125" y="2128997"/>
            <a:ext cx="542925" cy="2889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80696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86000" y="1905000"/>
            <a:ext cx="3962400" cy="2791599"/>
            <a:chOff x="1981200" y="2057400"/>
            <a:chExt cx="3962400" cy="2791599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67051023"/>
                </p:ext>
              </p:extLst>
            </p:nvPr>
          </p:nvGraphicFramePr>
          <p:xfrm>
            <a:off x="2286000" y="2057400"/>
            <a:ext cx="3657600" cy="2514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3657600" y="4572000"/>
              <a:ext cx="1059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Symbol" panose="05050102010706020507" pitchFamily="18" charset="2"/>
                </a:rPr>
                <a:t>DD</a:t>
              </a:r>
              <a:r>
                <a:rPr lang="en-US" sz="1200" b="1" dirty="0" smtClean="0"/>
                <a:t>CT p19ARF</a:t>
              </a:r>
              <a:endParaRPr lang="en-US" sz="1200" b="1" dirty="0"/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1628636" y="3180436"/>
              <a:ext cx="9821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Symbol" panose="05050102010706020507" pitchFamily="18" charset="2"/>
                </a:rPr>
                <a:t>DD</a:t>
              </a:r>
              <a:r>
                <a:rPr lang="en-US" sz="1200" b="1" dirty="0" smtClean="0"/>
                <a:t>CT JMJD6</a:t>
              </a:r>
              <a:endParaRPr lang="en-US" sz="1200" b="1" dirty="0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1447800" y="6093023"/>
            <a:ext cx="173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l Fig. </a:t>
            </a:r>
            <a:r>
              <a:rPr lang="en-US" sz="1400" b="1" dirty="0" smtClean="0"/>
              <a:t>S7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408584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2744380" y="1981200"/>
            <a:ext cx="3303995" cy="2586693"/>
            <a:chOff x="2744380" y="2285999"/>
            <a:chExt cx="3303995" cy="2586693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05067419"/>
                </p:ext>
              </p:extLst>
            </p:nvPr>
          </p:nvGraphicFramePr>
          <p:xfrm>
            <a:off x="3095625" y="2285999"/>
            <a:ext cx="2952750" cy="22860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 rot="16200000">
              <a:off x="2416342" y="3528439"/>
              <a:ext cx="9330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Calibri" panose="020F0502020204030204" pitchFamily="34" charset="0"/>
                </a:rPr>
                <a:t>Fold change</a:t>
              </a:r>
              <a:endParaRPr lang="en-US" sz="1200" dirty="0">
                <a:latin typeface="Calibri" panose="020F050202020403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636659" y="4410998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Calibri" panose="020F0502020204030204" pitchFamily="34" charset="0"/>
                </a:rPr>
                <a:t> </a:t>
              </a:r>
              <a:r>
                <a:rPr lang="en-US" sz="1000" dirty="0" err="1" smtClean="0">
                  <a:latin typeface="Calibri" panose="020F0502020204030204" pitchFamily="34" charset="0"/>
                </a:rPr>
                <a:t>LacZ</a:t>
              </a:r>
              <a:endParaRPr lang="en-US" sz="1000" dirty="0">
                <a:latin typeface="Calibri" panose="020F050202020403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726256" y="4619089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Calibri" panose="020F0502020204030204" pitchFamily="34" charset="0"/>
                </a:rPr>
                <a:t>anti-JMJD6</a:t>
              </a:r>
              <a:endParaRPr lang="en-US" sz="1000" dirty="0">
                <a:latin typeface="Calibri" panose="020F050202020403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674329" y="4626471"/>
              <a:ext cx="3577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Calibri" panose="020F0502020204030204" pitchFamily="34" charset="0"/>
                </a:rPr>
                <a:t>IgG</a:t>
              </a:r>
              <a:endParaRPr lang="en-US" sz="1000" dirty="0">
                <a:latin typeface="Calibri" panose="020F050202020403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257501" y="4416832"/>
              <a:ext cx="5212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Calibri" panose="020F0502020204030204" pitchFamily="34" charset="0"/>
                </a:rPr>
                <a:t>JMJD6</a:t>
              </a:r>
              <a:endParaRPr lang="en-US" sz="1000" dirty="0">
                <a:latin typeface="Calibri" panose="020F050202020403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451499" y="4410998"/>
              <a:ext cx="4427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Calibri" panose="020F0502020204030204" pitchFamily="34" charset="0"/>
                </a:rPr>
                <a:t> </a:t>
              </a:r>
              <a:r>
                <a:rPr lang="en-US" sz="1000" dirty="0" err="1" smtClean="0">
                  <a:latin typeface="Calibri" panose="020F0502020204030204" pitchFamily="34" charset="0"/>
                </a:rPr>
                <a:t>LacZ</a:t>
              </a:r>
              <a:endParaRPr lang="en-US" sz="1000" dirty="0">
                <a:latin typeface="Calibri" panose="020F0502020204030204" pitchFamily="34" charset="0"/>
              </a:endParaRP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4572000" y="4634537"/>
              <a:ext cx="10668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3588444" y="2362200"/>
              <a:ext cx="20319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Calibri" panose="020F0502020204030204" pitchFamily="34" charset="0"/>
                </a:rPr>
                <a:t>p16 promoter (</a:t>
              </a:r>
              <a:r>
                <a:rPr lang="en-US" sz="1200" dirty="0" err="1" smtClean="0">
                  <a:latin typeface="Calibri" panose="020F0502020204030204" pitchFamily="34" charset="0"/>
                </a:rPr>
                <a:t>NMuMG</a:t>
              </a:r>
              <a:r>
                <a:rPr lang="en-US" sz="1200" dirty="0" smtClean="0">
                  <a:latin typeface="Calibri" panose="020F0502020204030204" pitchFamily="34" charset="0"/>
                </a:rPr>
                <a:t> cells)</a:t>
              </a:r>
              <a:endParaRPr lang="en-US" sz="1200" dirty="0">
                <a:latin typeface="Calibri" panose="020F050202020403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920699" y="4616946"/>
              <a:ext cx="8050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Calibri" panose="020F0502020204030204" pitchFamily="34" charset="0"/>
                </a:rPr>
                <a:t>IP antibody:</a:t>
              </a:r>
              <a:endParaRPr lang="en-US" sz="1000" dirty="0">
                <a:latin typeface="Calibri" panose="020F0502020204030204" pitchFamily="34" charset="0"/>
              </a:endParaRP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1447800" y="6093023"/>
            <a:ext cx="173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upplemental Fig. </a:t>
            </a:r>
            <a:r>
              <a:rPr lang="en-US" sz="1400" b="1" dirty="0" smtClean="0"/>
              <a:t>S8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3631091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447800" y="685800"/>
            <a:ext cx="5375912" cy="5715000"/>
            <a:chOff x="1447800" y="685800"/>
            <a:chExt cx="5375912" cy="571500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80586574"/>
                </p:ext>
              </p:extLst>
            </p:nvPr>
          </p:nvGraphicFramePr>
          <p:xfrm>
            <a:off x="2286000" y="2514601"/>
            <a:ext cx="3124200" cy="18287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79452090"/>
                </p:ext>
              </p:extLst>
            </p:nvPr>
          </p:nvGraphicFramePr>
          <p:xfrm>
            <a:off x="2286000" y="685800"/>
            <a:ext cx="3124200" cy="18287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43313797"/>
                </p:ext>
              </p:extLst>
            </p:nvPr>
          </p:nvGraphicFramePr>
          <p:xfrm>
            <a:off x="2286000" y="4419600"/>
            <a:ext cx="3124200" cy="18287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1447800" y="6093023"/>
              <a:ext cx="173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Supplemental Fig. </a:t>
              </a:r>
              <a:r>
                <a:rPr lang="en-US" sz="1400" b="1" dirty="0" smtClean="0"/>
                <a:t>S9</a:t>
              </a:r>
              <a:endParaRPr lang="en-US" sz="1400" b="1" dirty="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6019800" y="1828800"/>
              <a:ext cx="152400" cy="1524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6019800" y="2057400"/>
              <a:ext cx="152400" cy="15240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134100" y="1781175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ycOFF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43625" y="1981200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yc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 Box 26"/>
            <p:cNvSpPr txBox="1">
              <a:spLocks noChangeArrowheads="1"/>
            </p:cNvSpPr>
            <p:nvPr/>
          </p:nvSpPr>
          <p:spPr bwMode="auto">
            <a:xfrm>
              <a:off x="3629025" y="1095375"/>
              <a:ext cx="325730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dirty="0" smtClean="0"/>
                <a:t>**</a:t>
              </a:r>
              <a:endParaRPr lang="en-US" altLang="en-US" sz="1400" dirty="0"/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3276600" y="1143000"/>
              <a:ext cx="914400" cy="341213"/>
              <a:chOff x="3276600" y="1143000"/>
              <a:chExt cx="914400" cy="341213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>
                <a:off x="3276600" y="1143000"/>
                <a:ext cx="9144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>
                <a:off x="4191000" y="1143000"/>
                <a:ext cx="0" cy="34121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" name="Text Box 26"/>
            <p:cNvSpPr txBox="1">
              <a:spLocks noChangeArrowheads="1"/>
            </p:cNvSpPr>
            <p:nvPr/>
          </p:nvSpPr>
          <p:spPr bwMode="auto">
            <a:xfrm>
              <a:off x="3581400" y="2940248"/>
              <a:ext cx="255198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dirty="0" smtClean="0"/>
                <a:t>*</a:t>
              </a:r>
              <a:endParaRPr lang="en-US" altLang="en-US" sz="1400" dirty="0"/>
            </a:p>
          </p:txBody>
        </p:sp>
        <p:sp>
          <p:nvSpPr>
            <p:cNvPr id="14" name="Text Box 26"/>
            <p:cNvSpPr txBox="1">
              <a:spLocks noChangeArrowheads="1"/>
            </p:cNvSpPr>
            <p:nvPr/>
          </p:nvSpPr>
          <p:spPr bwMode="auto">
            <a:xfrm>
              <a:off x="3600450" y="4826198"/>
              <a:ext cx="325730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dirty="0" smtClean="0"/>
                <a:t>**</a:t>
              </a:r>
              <a:endParaRPr lang="en-US" altLang="en-US" sz="1400" dirty="0"/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3257550" y="2983012"/>
              <a:ext cx="914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4171950" y="2983012"/>
              <a:ext cx="0" cy="1325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3276600" y="4896694"/>
              <a:ext cx="914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4191000" y="4896694"/>
              <a:ext cx="0" cy="1325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60244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15</TotalTime>
  <Words>213</Words>
  <Application>Microsoft Office PowerPoint</Application>
  <PresentationFormat>On-screen Show (4:3)</PresentationFormat>
  <Paragraphs>142</Paragraphs>
  <Slides>9</Slides>
  <Notes>5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Office Theme</vt:lpstr>
      <vt:lpstr>Chart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C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gistered User</dc:creator>
  <cp:lastModifiedBy>Registered User</cp:lastModifiedBy>
  <cp:revision>15</cp:revision>
  <dcterms:created xsi:type="dcterms:W3CDTF">2015-11-03T21:22:16Z</dcterms:created>
  <dcterms:modified xsi:type="dcterms:W3CDTF">2016-04-01T21:03:31Z</dcterms:modified>
</cp:coreProperties>
</file>